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45720000" cy="30268863"/>
  <p:notesSz cx="9144000" cy="6858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ABF8403-D0BB-41DD-A50F-7B66C8B8DAE6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2286000" y="1212840"/>
            <a:ext cx="41148000" cy="5043600"/>
          </a:xfrm>
          <a:prstGeom prst="rect">
            <a:avLst/>
          </a:prstGeom>
          <a:noFill/>
          <a:ln w="0">
            <a:noFill/>
          </a:ln>
        </p:spPr>
        <p:txBody>
          <a:bodyPr lIns="417600" rIns="417600" tIns="208800" bIns="208800" anchor="ctr">
            <a:noAutofit/>
          </a:bodyPr>
          <a:p>
            <a:pPr indent="0" algn="ctr">
              <a:buNone/>
              <a:tabLst>
                <a:tab algn="l" pos="0"/>
                <a:tab algn="l" pos="4175280"/>
                <a:tab algn="l" pos="8350200"/>
              </a:tabLst>
            </a:pPr>
            <a:endParaRPr b="0" lang="en-US" sz="20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2286000" y="7062480"/>
            <a:ext cx="41148000" cy="9527400"/>
          </a:xfrm>
          <a:prstGeom prst="rect">
            <a:avLst/>
          </a:prstGeom>
          <a:noFill/>
          <a:ln w="0">
            <a:noFill/>
          </a:ln>
        </p:spPr>
        <p:txBody>
          <a:bodyPr lIns="417600" rIns="417600" tIns="208800" bIns="208800" anchor="t">
            <a:normAutofit/>
          </a:bodyPr>
          <a:p>
            <a:pPr indent="0">
              <a:spcBef>
                <a:spcPts val="3651"/>
              </a:spcBef>
              <a:buNone/>
              <a:tabLst>
                <a:tab algn="l" pos="4175280"/>
                <a:tab algn="l" pos="8350200"/>
              </a:tabLst>
            </a:pPr>
            <a:endParaRPr b="0" lang="en-US" sz="14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2286000" y="17495280"/>
            <a:ext cx="41148000" cy="9527400"/>
          </a:xfrm>
          <a:prstGeom prst="rect">
            <a:avLst/>
          </a:prstGeom>
          <a:noFill/>
          <a:ln w="0">
            <a:noFill/>
          </a:ln>
        </p:spPr>
        <p:txBody>
          <a:bodyPr lIns="417600" rIns="417600" tIns="208800" bIns="208800" anchor="t">
            <a:normAutofit/>
          </a:bodyPr>
          <a:p>
            <a:pPr indent="0">
              <a:spcBef>
                <a:spcPts val="3651"/>
              </a:spcBef>
              <a:buNone/>
              <a:tabLst>
                <a:tab algn="l" pos="4175280"/>
                <a:tab algn="l" pos="8350200"/>
              </a:tabLst>
            </a:pPr>
            <a:endParaRPr b="0" lang="en-US" sz="14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ED4F6CA-C6E1-4B50-9774-9E65DBC5D75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2286000" y="1212840"/>
            <a:ext cx="41148000" cy="5043600"/>
          </a:xfrm>
          <a:prstGeom prst="rect">
            <a:avLst/>
          </a:prstGeom>
          <a:noFill/>
          <a:ln w="0">
            <a:noFill/>
          </a:ln>
        </p:spPr>
        <p:txBody>
          <a:bodyPr lIns="417600" rIns="417600" tIns="208800" bIns="208800" anchor="ctr">
            <a:noAutofit/>
          </a:bodyPr>
          <a:p>
            <a:pPr indent="0" algn="ctr">
              <a:buNone/>
              <a:tabLst>
                <a:tab algn="l" pos="0"/>
                <a:tab algn="l" pos="4175280"/>
                <a:tab algn="l" pos="8350200"/>
              </a:tabLst>
            </a:pPr>
            <a:endParaRPr b="0" lang="en-US" sz="20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2286000" y="7062480"/>
            <a:ext cx="20080080" cy="9527400"/>
          </a:xfrm>
          <a:prstGeom prst="rect">
            <a:avLst/>
          </a:prstGeom>
          <a:noFill/>
          <a:ln w="0">
            <a:noFill/>
          </a:ln>
        </p:spPr>
        <p:txBody>
          <a:bodyPr lIns="417600" rIns="417600" tIns="208800" bIns="208800" anchor="t">
            <a:normAutofit/>
          </a:bodyPr>
          <a:p>
            <a:pPr indent="0">
              <a:spcBef>
                <a:spcPts val="3651"/>
              </a:spcBef>
              <a:buNone/>
              <a:tabLst>
                <a:tab algn="l" pos="4175280"/>
                <a:tab algn="l" pos="8350200"/>
              </a:tabLst>
            </a:pPr>
            <a:endParaRPr b="0" lang="en-US" sz="14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23370480" y="7062480"/>
            <a:ext cx="20080080" cy="9527400"/>
          </a:xfrm>
          <a:prstGeom prst="rect">
            <a:avLst/>
          </a:prstGeom>
          <a:noFill/>
          <a:ln w="0">
            <a:noFill/>
          </a:ln>
        </p:spPr>
        <p:txBody>
          <a:bodyPr lIns="417600" rIns="417600" tIns="208800" bIns="208800" anchor="t">
            <a:normAutofit/>
          </a:bodyPr>
          <a:p>
            <a:pPr indent="0">
              <a:spcBef>
                <a:spcPts val="3651"/>
              </a:spcBef>
              <a:buNone/>
              <a:tabLst>
                <a:tab algn="l" pos="4175280"/>
                <a:tab algn="l" pos="8350200"/>
              </a:tabLst>
            </a:pPr>
            <a:endParaRPr b="0" lang="en-US" sz="14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2286000" y="17495280"/>
            <a:ext cx="20080080" cy="9527400"/>
          </a:xfrm>
          <a:prstGeom prst="rect">
            <a:avLst/>
          </a:prstGeom>
          <a:noFill/>
          <a:ln w="0">
            <a:noFill/>
          </a:ln>
        </p:spPr>
        <p:txBody>
          <a:bodyPr lIns="417600" rIns="417600" tIns="208800" bIns="208800" anchor="t">
            <a:normAutofit/>
          </a:bodyPr>
          <a:p>
            <a:pPr indent="0">
              <a:spcBef>
                <a:spcPts val="3651"/>
              </a:spcBef>
              <a:buNone/>
              <a:tabLst>
                <a:tab algn="l" pos="4175280"/>
                <a:tab algn="l" pos="8350200"/>
              </a:tabLst>
            </a:pPr>
            <a:endParaRPr b="0" lang="en-US" sz="14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23370480" y="17495280"/>
            <a:ext cx="20080080" cy="9527400"/>
          </a:xfrm>
          <a:prstGeom prst="rect">
            <a:avLst/>
          </a:prstGeom>
          <a:noFill/>
          <a:ln w="0">
            <a:noFill/>
          </a:ln>
        </p:spPr>
        <p:txBody>
          <a:bodyPr lIns="417600" rIns="417600" tIns="208800" bIns="208800" anchor="t">
            <a:normAutofit/>
          </a:bodyPr>
          <a:p>
            <a:pPr indent="0">
              <a:spcBef>
                <a:spcPts val="3651"/>
              </a:spcBef>
              <a:buNone/>
              <a:tabLst>
                <a:tab algn="l" pos="4175280"/>
                <a:tab algn="l" pos="8350200"/>
              </a:tabLst>
            </a:pPr>
            <a:endParaRPr b="0" lang="en-US" sz="14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CAD3CE4-DE81-4D0B-B013-5855E892108E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2286000" y="1212840"/>
            <a:ext cx="41148000" cy="5043600"/>
          </a:xfrm>
          <a:prstGeom prst="rect">
            <a:avLst/>
          </a:prstGeom>
          <a:noFill/>
          <a:ln w="0">
            <a:noFill/>
          </a:ln>
        </p:spPr>
        <p:txBody>
          <a:bodyPr lIns="417600" rIns="417600" tIns="208800" bIns="208800" anchor="ctr">
            <a:noAutofit/>
          </a:bodyPr>
          <a:p>
            <a:pPr indent="0" algn="ctr">
              <a:buNone/>
              <a:tabLst>
                <a:tab algn="l" pos="0"/>
                <a:tab algn="l" pos="4175280"/>
                <a:tab algn="l" pos="8350200"/>
              </a:tabLst>
            </a:pPr>
            <a:endParaRPr b="0" lang="en-US" sz="20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2286000" y="7062480"/>
            <a:ext cx="13249440" cy="9527400"/>
          </a:xfrm>
          <a:prstGeom prst="rect">
            <a:avLst/>
          </a:prstGeom>
          <a:noFill/>
          <a:ln w="0">
            <a:noFill/>
          </a:ln>
        </p:spPr>
        <p:txBody>
          <a:bodyPr lIns="417600" rIns="417600" tIns="208800" bIns="208800" anchor="t">
            <a:normAutofit/>
          </a:bodyPr>
          <a:p>
            <a:pPr indent="0">
              <a:spcBef>
                <a:spcPts val="3651"/>
              </a:spcBef>
              <a:buNone/>
              <a:tabLst>
                <a:tab algn="l" pos="4175280"/>
                <a:tab algn="l" pos="8350200"/>
              </a:tabLst>
            </a:pPr>
            <a:endParaRPr b="0" lang="en-US" sz="14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16198200" y="7062480"/>
            <a:ext cx="13249440" cy="9527400"/>
          </a:xfrm>
          <a:prstGeom prst="rect">
            <a:avLst/>
          </a:prstGeom>
          <a:noFill/>
          <a:ln w="0">
            <a:noFill/>
          </a:ln>
        </p:spPr>
        <p:txBody>
          <a:bodyPr lIns="417600" rIns="417600" tIns="208800" bIns="208800" anchor="t">
            <a:normAutofit/>
          </a:bodyPr>
          <a:p>
            <a:pPr indent="0">
              <a:spcBef>
                <a:spcPts val="3651"/>
              </a:spcBef>
              <a:buNone/>
              <a:tabLst>
                <a:tab algn="l" pos="4175280"/>
                <a:tab algn="l" pos="8350200"/>
              </a:tabLst>
            </a:pPr>
            <a:endParaRPr b="0" lang="en-US" sz="14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30110760" y="7062480"/>
            <a:ext cx="13249440" cy="9527400"/>
          </a:xfrm>
          <a:prstGeom prst="rect">
            <a:avLst/>
          </a:prstGeom>
          <a:noFill/>
          <a:ln w="0">
            <a:noFill/>
          </a:ln>
        </p:spPr>
        <p:txBody>
          <a:bodyPr lIns="417600" rIns="417600" tIns="208800" bIns="208800" anchor="t">
            <a:normAutofit/>
          </a:bodyPr>
          <a:p>
            <a:pPr indent="0">
              <a:spcBef>
                <a:spcPts val="3651"/>
              </a:spcBef>
              <a:buNone/>
              <a:tabLst>
                <a:tab algn="l" pos="4175280"/>
                <a:tab algn="l" pos="8350200"/>
              </a:tabLst>
            </a:pPr>
            <a:endParaRPr b="0" lang="en-US" sz="14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2286000" y="17495280"/>
            <a:ext cx="13249440" cy="9527400"/>
          </a:xfrm>
          <a:prstGeom prst="rect">
            <a:avLst/>
          </a:prstGeom>
          <a:noFill/>
          <a:ln w="0">
            <a:noFill/>
          </a:ln>
        </p:spPr>
        <p:txBody>
          <a:bodyPr lIns="417600" rIns="417600" tIns="208800" bIns="208800" anchor="t">
            <a:normAutofit/>
          </a:bodyPr>
          <a:p>
            <a:pPr indent="0">
              <a:spcBef>
                <a:spcPts val="3651"/>
              </a:spcBef>
              <a:buNone/>
              <a:tabLst>
                <a:tab algn="l" pos="4175280"/>
                <a:tab algn="l" pos="8350200"/>
              </a:tabLst>
            </a:pPr>
            <a:endParaRPr b="0" lang="en-US" sz="14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16198200" y="17495280"/>
            <a:ext cx="13249440" cy="9527400"/>
          </a:xfrm>
          <a:prstGeom prst="rect">
            <a:avLst/>
          </a:prstGeom>
          <a:noFill/>
          <a:ln w="0">
            <a:noFill/>
          </a:ln>
        </p:spPr>
        <p:txBody>
          <a:bodyPr lIns="417600" rIns="417600" tIns="208800" bIns="208800" anchor="t">
            <a:normAutofit/>
          </a:bodyPr>
          <a:p>
            <a:pPr indent="0">
              <a:spcBef>
                <a:spcPts val="3651"/>
              </a:spcBef>
              <a:buNone/>
              <a:tabLst>
                <a:tab algn="l" pos="4175280"/>
                <a:tab algn="l" pos="8350200"/>
              </a:tabLst>
            </a:pPr>
            <a:endParaRPr b="0" lang="en-US" sz="14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30110760" y="17495280"/>
            <a:ext cx="13249440" cy="9527400"/>
          </a:xfrm>
          <a:prstGeom prst="rect">
            <a:avLst/>
          </a:prstGeom>
          <a:noFill/>
          <a:ln w="0">
            <a:noFill/>
          </a:ln>
        </p:spPr>
        <p:txBody>
          <a:bodyPr lIns="417600" rIns="417600" tIns="208800" bIns="208800" anchor="t">
            <a:normAutofit/>
          </a:bodyPr>
          <a:p>
            <a:pPr indent="0">
              <a:spcBef>
                <a:spcPts val="3651"/>
              </a:spcBef>
              <a:buNone/>
              <a:tabLst>
                <a:tab algn="l" pos="4175280"/>
                <a:tab algn="l" pos="8350200"/>
              </a:tabLst>
            </a:pPr>
            <a:endParaRPr b="0" lang="en-US" sz="14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33A7479-4C03-4716-B17F-1AB328BD16BC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2286000" y="1212840"/>
            <a:ext cx="41148000" cy="5043600"/>
          </a:xfrm>
          <a:prstGeom prst="rect">
            <a:avLst/>
          </a:prstGeom>
          <a:noFill/>
          <a:ln w="0">
            <a:noFill/>
          </a:ln>
        </p:spPr>
        <p:txBody>
          <a:bodyPr lIns="417600" rIns="417600" tIns="208800" bIns="208800" anchor="ctr">
            <a:noAutofit/>
          </a:bodyPr>
          <a:p>
            <a:pPr indent="0" algn="ctr">
              <a:buNone/>
              <a:tabLst>
                <a:tab algn="l" pos="0"/>
                <a:tab algn="l" pos="4175280"/>
                <a:tab algn="l" pos="8350200"/>
              </a:tabLst>
            </a:pPr>
            <a:endParaRPr b="0" lang="en-US" sz="20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2286000" y="7062480"/>
            <a:ext cx="41148000" cy="199738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3651"/>
              </a:spcBef>
              <a:buNone/>
              <a:tabLst>
                <a:tab algn="l" pos="0"/>
                <a:tab algn="l" pos="4175280"/>
                <a:tab algn="l" pos="8350200"/>
              </a:tabLst>
            </a:pPr>
            <a:endParaRPr b="0" lang="en-US" sz="14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543D7D6-B1DE-4907-8277-D958CF3A96E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2286000" y="1212840"/>
            <a:ext cx="41148000" cy="5043600"/>
          </a:xfrm>
          <a:prstGeom prst="rect">
            <a:avLst/>
          </a:prstGeom>
          <a:noFill/>
          <a:ln w="0">
            <a:noFill/>
          </a:ln>
        </p:spPr>
        <p:txBody>
          <a:bodyPr lIns="417600" rIns="417600" tIns="208800" bIns="208800" anchor="ctr">
            <a:noAutofit/>
          </a:bodyPr>
          <a:p>
            <a:pPr indent="0" algn="ctr">
              <a:buNone/>
              <a:tabLst>
                <a:tab algn="l" pos="0"/>
                <a:tab algn="l" pos="4175280"/>
                <a:tab algn="l" pos="8350200"/>
              </a:tabLst>
            </a:pPr>
            <a:endParaRPr b="0" lang="en-US" sz="20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2286000" y="7062480"/>
            <a:ext cx="41148000" cy="19973880"/>
          </a:xfrm>
          <a:prstGeom prst="rect">
            <a:avLst/>
          </a:prstGeom>
          <a:noFill/>
          <a:ln w="0">
            <a:noFill/>
          </a:ln>
        </p:spPr>
        <p:txBody>
          <a:bodyPr lIns="417600" rIns="417600" tIns="208800" bIns="208800" anchor="t">
            <a:normAutofit/>
          </a:bodyPr>
          <a:p>
            <a:pPr indent="0">
              <a:spcBef>
                <a:spcPts val="3651"/>
              </a:spcBef>
              <a:buNone/>
              <a:tabLst>
                <a:tab algn="l" pos="4175280"/>
                <a:tab algn="l" pos="8350200"/>
              </a:tabLst>
            </a:pPr>
            <a:endParaRPr b="0" lang="en-US" sz="14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4F69F9E-DD0D-468D-A5F4-3FE12034968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2286000" y="1212840"/>
            <a:ext cx="41148000" cy="5043600"/>
          </a:xfrm>
          <a:prstGeom prst="rect">
            <a:avLst/>
          </a:prstGeom>
          <a:noFill/>
          <a:ln w="0">
            <a:noFill/>
          </a:ln>
        </p:spPr>
        <p:txBody>
          <a:bodyPr lIns="417600" rIns="417600" tIns="208800" bIns="208800" anchor="ctr">
            <a:noAutofit/>
          </a:bodyPr>
          <a:p>
            <a:pPr indent="0" algn="ctr">
              <a:buNone/>
              <a:tabLst>
                <a:tab algn="l" pos="0"/>
                <a:tab algn="l" pos="4175280"/>
                <a:tab algn="l" pos="8350200"/>
              </a:tabLst>
            </a:pPr>
            <a:endParaRPr b="0" lang="en-US" sz="20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2286000" y="7062480"/>
            <a:ext cx="20080080" cy="19973880"/>
          </a:xfrm>
          <a:prstGeom prst="rect">
            <a:avLst/>
          </a:prstGeom>
          <a:noFill/>
          <a:ln w="0">
            <a:noFill/>
          </a:ln>
        </p:spPr>
        <p:txBody>
          <a:bodyPr lIns="417600" rIns="417600" tIns="208800" bIns="208800" anchor="t">
            <a:normAutofit/>
          </a:bodyPr>
          <a:p>
            <a:pPr indent="0">
              <a:spcBef>
                <a:spcPts val="3651"/>
              </a:spcBef>
              <a:buNone/>
              <a:tabLst>
                <a:tab algn="l" pos="4175280"/>
                <a:tab algn="l" pos="8350200"/>
              </a:tabLst>
            </a:pPr>
            <a:endParaRPr b="0" lang="en-US" sz="14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23370480" y="7062480"/>
            <a:ext cx="20080080" cy="19973880"/>
          </a:xfrm>
          <a:prstGeom prst="rect">
            <a:avLst/>
          </a:prstGeom>
          <a:noFill/>
          <a:ln w="0">
            <a:noFill/>
          </a:ln>
        </p:spPr>
        <p:txBody>
          <a:bodyPr lIns="417600" rIns="417600" tIns="208800" bIns="208800" anchor="t">
            <a:normAutofit/>
          </a:bodyPr>
          <a:p>
            <a:pPr indent="0">
              <a:spcBef>
                <a:spcPts val="3651"/>
              </a:spcBef>
              <a:buNone/>
              <a:tabLst>
                <a:tab algn="l" pos="4175280"/>
                <a:tab algn="l" pos="8350200"/>
              </a:tabLst>
            </a:pPr>
            <a:endParaRPr b="0" lang="en-US" sz="14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C362916-8761-47BA-99C9-67D6A2284BC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2286000" y="1212840"/>
            <a:ext cx="41148000" cy="5043600"/>
          </a:xfrm>
          <a:prstGeom prst="rect">
            <a:avLst/>
          </a:prstGeom>
          <a:noFill/>
          <a:ln w="0">
            <a:noFill/>
          </a:ln>
        </p:spPr>
        <p:txBody>
          <a:bodyPr lIns="417600" rIns="417600" tIns="208800" bIns="208800" anchor="ctr">
            <a:noAutofit/>
          </a:bodyPr>
          <a:p>
            <a:pPr indent="0" algn="ctr">
              <a:buNone/>
              <a:tabLst>
                <a:tab algn="l" pos="0"/>
                <a:tab algn="l" pos="4175280"/>
                <a:tab algn="l" pos="8350200"/>
              </a:tabLst>
            </a:pPr>
            <a:endParaRPr b="0" lang="en-US" sz="20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4587E69-3548-4C8D-A4AA-18AC386E581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2286000" y="1212840"/>
            <a:ext cx="41148000" cy="23380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3651"/>
              </a:spcBef>
              <a:tabLst>
                <a:tab algn="l" pos="0"/>
                <a:tab algn="l" pos="4175280"/>
                <a:tab algn="l" pos="8350200"/>
              </a:tabLst>
            </a:pPr>
            <a:endParaRPr b="0" lang="en-US" sz="14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62926B0-D077-4692-8F60-60E1DBE26E6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2286000" y="1212840"/>
            <a:ext cx="41148000" cy="5043600"/>
          </a:xfrm>
          <a:prstGeom prst="rect">
            <a:avLst/>
          </a:prstGeom>
          <a:noFill/>
          <a:ln w="0">
            <a:noFill/>
          </a:ln>
        </p:spPr>
        <p:txBody>
          <a:bodyPr lIns="417600" rIns="417600" tIns="208800" bIns="208800" anchor="ctr">
            <a:noAutofit/>
          </a:bodyPr>
          <a:p>
            <a:pPr indent="0" algn="ctr">
              <a:buNone/>
              <a:tabLst>
                <a:tab algn="l" pos="0"/>
                <a:tab algn="l" pos="4175280"/>
                <a:tab algn="l" pos="8350200"/>
              </a:tabLst>
            </a:pPr>
            <a:endParaRPr b="0" lang="en-US" sz="20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2286000" y="7062480"/>
            <a:ext cx="20080080" cy="9527400"/>
          </a:xfrm>
          <a:prstGeom prst="rect">
            <a:avLst/>
          </a:prstGeom>
          <a:noFill/>
          <a:ln w="0">
            <a:noFill/>
          </a:ln>
        </p:spPr>
        <p:txBody>
          <a:bodyPr lIns="417600" rIns="417600" tIns="208800" bIns="208800" anchor="t">
            <a:normAutofit/>
          </a:bodyPr>
          <a:p>
            <a:pPr indent="0">
              <a:spcBef>
                <a:spcPts val="3651"/>
              </a:spcBef>
              <a:buNone/>
              <a:tabLst>
                <a:tab algn="l" pos="4175280"/>
                <a:tab algn="l" pos="8350200"/>
              </a:tabLst>
            </a:pPr>
            <a:endParaRPr b="0" lang="en-US" sz="14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23370480" y="7062480"/>
            <a:ext cx="20080080" cy="19973880"/>
          </a:xfrm>
          <a:prstGeom prst="rect">
            <a:avLst/>
          </a:prstGeom>
          <a:noFill/>
          <a:ln w="0">
            <a:noFill/>
          </a:ln>
        </p:spPr>
        <p:txBody>
          <a:bodyPr lIns="417600" rIns="417600" tIns="208800" bIns="208800" anchor="t">
            <a:normAutofit/>
          </a:bodyPr>
          <a:p>
            <a:pPr indent="0">
              <a:spcBef>
                <a:spcPts val="3651"/>
              </a:spcBef>
              <a:buNone/>
              <a:tabLst>
                <a:tab algn="l" pos="4175280"/>
                <a:tab algn="l" pos="8350200"/>
              </a:tabLst>
            </a:pPr>
            <a:endParaRPr b="0" lang="en-US" sz="14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2286000" y="17495280"/>
            <a:ext cx="20080080" cy="9527400"/>
          </a:xfrm>
          <a:prstGeom prst="rect">
            <a:avLst/>
          </a:prstGeom>
          <a:noFill/>
          <a:ln w="0">
            <a:noFill/>
          </a:ln>
        </p:spPr>
        <p:txBody>
          <a:bodyPr lIns="417600" rIns="417600" tIns="208800" bIns="208800" anchor="t">
            <a:normAutofit/>
          </a:bodyPr>
          <a:p>
            <a:pPr indent="0">
              <a:spcBef>
                <a:spcPts val="3651"/>
              </a:spcBef>
              <a:buNone/>
              <a:tabLst>
                <a:tab algn="l" pos="4175280"/>
                <a:tab algn="l" pos="8350200"/>
              </a:tabLst>
            </a:pPr>
            <a:endParaRPr b="0" lang="en-US" sz="14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3636F81-73A3-4A6F-AF46-29E18BDA7A9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2286000" y="1212840"/>
            <a:ext cx="41148000" cy="5043600"/>
          </a:xfrm>
          <a:prstGeom prst="rect">
            <a:avLst/>
          </a:prstGeom>
          <a:noFill/>
          <a:ln w="0">
            <a:noFill/>
          </a:ln>
        </p:spPr>
        <p:txBody>
          <a:bodyPr lIns="417600" rIns="417600" tIns="208800" bIns="208800" anchor="ctr">
            <a:noAutofit/>
          </a:bodyPr>
          <a:p>
            <a:pPr indent="0" algn="ctr">
              <a:buNone/>
              <a:tabLst>
                <a:tab algn="l" pos="0"/>
                <a:tab algn="l" pos="4175280"/>
                <a:tab algn="l" pos="8350200"/>
              </a:tabLst>
            </a:pPr>
            <a:endParaRPr b="0" lang="en-US" sz="20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2286000" y="7062480"/>
            <a:ext cx="20080080" cy="19973880"/>
          </a:xfrm>
          <a:prstGeom prst="rect">
            <a:avLst/>
          </a:prstGeom>
          <a:noFill/>
          <a:ln w="0">
            <a:noFill/>
          </a:ln>
        </p:spPr>
        <p:txBody>
          <a:bodyPr lIns="417600" rIns="417600" tIns="208800" bIns="208800" anchor="t">
            <a:normAutofit/>
          </a:bodyPr>
          <a:p>
            <a:pPr indent="0">
              <a:spcBef>
                <a:spcPts val="3651"/>
              </a:spcBef>
              <a:buNone/>
              <a:tabLst>
                <a:tab algn="l" pos="4175280"/>
                <a:tab algn="l" pos="8350200"/>
              </a:tabLst>
            </a:pPr>
            <a:endParaRPr b="0" lang="en-US" sz="14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23370480" y="7062480"/>
            <a:ext cx="20080080" cy="9527400"/>
          </a:xfrm>
          <a:prstGeom prst="rect">
            <a:avLst/>
          </a:prstGeom>
          <a:noFill/>
          <a:ln w="0">
            <a:noFill/>
          </a:ln>
        </p:spPr>
        <p:txBody>
          <a:bodyPr lIns="417600" rIns="417600" tIns="208800" bIns="208800" anchor="t">
            <a:normAutofit/>
          </a:bodyPr>
          <a:p>
            <a:pPr indent="0">
              <a:spcBef>
                <a:spcPts val="3651"/>
              </a:spcBef>
              <a:buNone/>
              <a:tabLst>
                <a:tab algn="l" pos="4175280"/>
                <a:tab algn="l" pos="8350200"/>
              </a:tabLst>
            </a:pPr>
            <a:endParaRPr b="0" lang="en-US" sz="14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23370480" y="17495280"/>
            <a:ext cx="20080080" cy="9527400"/>
          </a:xfrm>
          <a:prstGeom prst="rect">
            <a:avLst/>
          </a:prstGeom>
          <a:noFill/>
          <a:ln w="0">
            <a:noFill/>
          </a:ln>
        </p:spPr>
        <p:txBody>
          <a:bodyPr lIns="417600" rIns="417600" tIns="208800" bIns="208800" anchor="t">
            <a:normAutofit/>
          </a:bodyPr>
          <a:p>
            <a:pPr indent="0">
              <a:spcBef>
                <a:spcPts val="3651"/>
              </a:spcBef>
              <a:buNone/>
              <a:tabLst>
                <a:tab algn="l" pos="4175280"/>
                <a:tab algn="l" pos="8350200"/>
              </a:tabLst>
            </a:pPr>
            <a:endParaRPr b="0" lang="en-US" sz="14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A611E09-A4C2-47E3-946B-D2098985575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2286000" y="1212840"/>
            <a:ext cx="41148000" cy="5043600"/>
          </a:xfrm>
          <a:prstGeom prst="rect">
            <a:avLst/>
          </a:prstGeom>
          <a:noFill/>
          <a:ln w="0">
            <a:noFill/>
          </a:ln>
        </p:spPr>
        <p:txBody>
          <a:bodyPr lIns="417600" rIns="417600" tIns="208800" bIns="208800" anchor="ctr">
            <a:noAutofit/>
          </a:bodyPr>
          <a:p>
            <a:pPr indent="0" algn="ctr">
              <a:buNone/>
              <a:tabLst>
                <a:tab algn="l" pos="0"/>
                <a:tab algn="l" pos="4175280"/>
                <a:tab algn="l" pos="8350200"/>
              </a:tabLst>
            </a:pPr>
            <a:endParaRPr b="0" lang="en-US" sz="20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2286000" y="7062480"/>
            <a:ext cx="20080080" cy="9527400"/>
          </a:xfrm>
          <a:prstGeom prst="rect">
            <a:avLst/>
          </a:prstGeom>
          <a:noFill/>
          <a:ln w="0">
            <a:noFill/>
          </a:ln>
        </p:spPr>
        <p:txBody>
          <a:bodyPr lIns="417600" rIns="417600" tIns="208800" bIns="208800" anchor="t">
            <a:normAutofit/>
          </a:bodyPr>
          <a:p>
            <a:pPr indent="0">
              <a:spcBef>
                <a:spcPts val="3651"/>
              </a:spcBef>
              <a:buNone/>
              <a:tabLst>
                <a:tab algn="l" pos="4175280"/>
                <a:tab algn="l" pos="8350200"/>
              </a:tabLst>
            </a:pPr>
            <a:endParaRPr b="0" lang="en-US" sz="14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23370480" y="7062480"/>
            <a:ext cx="20080080" cy="9527400"/>
          </a:xfrm>
          <a:prstGeom prst="rect">
            <a:avLst/>
          </a:prstGeom>
          <a:noFill/>
          <a:ln w="0">
            <a:noFill/>
          </a:ln>
        </p:spPr>
        <p:txBody>
          <a:bodyPr lIns="417600" rIns="417600" tIns="208800" bIns="208800" anchor="t">
            <a:normAutofit/>
          </a:bodyPr>
          <a:p>
            <a:pPr indent="0">
              <a:spcBef>
                <a:spcPts val="3651"/>
              </a:spcBef>
              <a:buNone/>
              <a:tabLst>
                <a:tab algn="l" pos="4175280"/>
                <a:tab algn="l" pos="8350200"/>
              </a:tabLst>
            </a:pPr>
            <a:endParaRPr b="0" lang="en-US" sz="14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2286000" y="17495280"/>
            <a:ext cx="41148000" cy="9527400"/>
          </a:xfrm>
          <a:prstGeom prst="rect">
            <a:avLst/>
          </a:prstGeom>
          <a:noFill/>
          <a:ln w="0">
            <a:noFill/>
          </a:ln>
        </p:spPr>
        <p:txBody>
          <a:bodyPr lIns="417600" rIns="417600" tIns="208800" bIns="208800" anchor="t">
            <a:normAutofit/>
          </a:bodyPr>
          <a:p>
            <a:pPr indent="0">
              <a:spcBef>
                <a:spcPts val="3651"/>
              </a:spcBef>
              <a:buNone/>
              <a:tabLst>
                <a:tab algn="l" pos="4175280"/>
                <a:tab algn="l" pos="8350200"/>
              </a:tabLst>
            </a:pPr>
            <a:endParaRPr b="0" lang="en-US" sz="14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8FF69E4-490A-46AD-AA52-19B5A5877AC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2286000" y="1212840"/>
            <a:ext cx="41148000" cy="5043600"/>
          </a:xfrm>
          <a:prstGeom prst="rect">
            <a:avLst/>
          </a:prstGeom>
          <a:noFill/>
          <a:ln w="0">
            <a:noFill/>
          </a:ln>
        </p:spPr>
        <p:txBody>
          <a:bodyPr lIns="417600" rIns="417600" tIns="208800" bIns="208800" anchor="ctr">
            <a:noAutofit/>
          </a:bodyPr>
          <a:p>
            <a:pPr indent="0" algn="ctr">
              <a:buNone/>
              <a:tabLst>
                <a:tab algn="l" pos="0"/>
                <a:tab algn="l" pos="4175280"/>
                <a:tab algn="l" pos="8350200"/>
              </a:tabLst>
            </a:pPr>
            <a:r>
              <a:rPr b="0" lang="en-US" sz="201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20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2286000" y="7062480"/>
            <a:ext cx="41148000" cy="19973880"/>
          </a:xfrm>
          <a:prstGeom prst="rect">
            <a:avLst/>
          </a:prstGeom>
          <a:noFill/>
          <a:ln w="0">
            <a:noFill/>
          </a:ln>
        </p:spPr>
        <p:txBody>
          <a:bodyPr lIns="417600" rIns="417600" tIns="208800" bIns="208800" anchor="t">
            <a:normAutofit/>
          </a:bodyPr>
          <a:p>
            <a:pPr marL="1565280" indent="-1565280">
              <a:spcBef>
                <a:spcPts val="3651"/>
              </a:spcBef>
              <a:buClr>
                <a:srgbClr val="000000"/>
              </a:buClr>
              <a:buFont typeface="Arial"/>
              <a:buChar char="•"/>
              <a:tabLst>
                <a:tab algn="l" pos="4175280"/>
                <a:tab algn="l" pos="8350200"/>
              </a:tabLst>
            </a:pPr>
            <a:r>
              <a:rPr b="0" lang="en-US" sz="146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14600" spc="-1" strike="noStrike">
              <a:solidFill>
                <a:srgbClr val="000000"/>
              </a:solidFill>
              <a:latin typeface="Arial"/>
            </a:endParaRPr>
          </a:p>
          <a:p>
            <a:pPr lvl="1" marL="3392640" indent="-1305000">
              <a:spcBef>
                <a:spcPts val="3651"/>
              </a:spcBef>
              <a:buClr>
                <a:srgbClr val="000000"/>
              </a:buClr>
              <a:buFont typeface="Arial"/>
              <a:buChar char="–"/>
              <a:tabLst>
                <a:tab algn="l" pos="4175280"/>
                <a:tab algn="l" pos="8350200"/>
              </a:tabLst>
            </a:pPr>
            <a:r>
              <a:rPr b="0" lang="en-US" sz="146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14600" spc="-1" strike="noStrike">
              <a:solidFill>
                <a:srgbClr val="000000"/>
              </a:solidFill>
              <a:latin typeface="Arial"/>
            </a:endParaRPr>
          </a:p>
          <a:p>
            <a:pPr lvl="2" marL="5218200" indent="-1042920">
              <a:spcBef>
                <a:spcPts val="3651"/>
              </a:spcBef>
              <a:buClr>
                <a:srgbClr val="000000"/>
              </a:buClr>
              <a:buFont typeface="Arial"/>
              <a:buChar char="•"/>
              <a:tabLst>
                <a:tab algn="l" pos="4175280"/>
                <a:tab algn="l" pos="8350200"/>
              </a:tabLst>
            </a:pPr>
            <a:r>
              <a:rPr b="0" lang="en-US" sz="146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14600" spc="-1" strike="noStrike">
              <a:solidFill>
                <a:srgbClr val="000000"/>
              </a:solidFill>
              <a:latin typeface="Arial"/>
            </a:endParaRPr>
          </a:p>
          <a:p>
            <a:pPr lvl="3" marL="7305840" indent="-1043280">
              <a:spcBef>
                <a:spcPts val="3651"/>
              </a:spcBef>
              <a:buClr>
                <a:srgbClr val="000000"/>
              </a:buClr>
              <a:buFont typeface="Arial"/>
              <a:buChar char="–"/>
              <a:tabLst>
                <a:tab algn="l" pos="4175280"/>
                <a:tab algn="l" pos="8350200"/>
              </a:tabLst>
            </a:pPr>
            <a:r>
              <a:rPr b="0" lang="en-US" sz="146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14600" spc="-1" strike="noStrike">
              <a:solidFill>
                <a:srgbClr val="000000"/>
              </a:solidFill>
              <a:latin typeface="Arial"/>
            </a:endParaRPr>
          </a:p>
          <a:p>
            <a:pPr lvl="4" marL="9393120" indent="-1042920">
              <a:spcBef>
                <a:spcPts val="3651"/>
              </a:spcBef>
              <a:buClr>
                <a:srgbClr val="000000"/>
              </a:buClr>
              <a:buFont typeface="Arial"/>
              <a:buChar char="»"/>
              <a:tabLst>
                <a:tab algn="l" pos="4175280"/>
                <a:tab algn="l" pos="8350200"/>
              </a:tabLst>
            </a:pPr>
            <a:r>
              <a:rPr b="0" lang="en-US" sz="146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14600" spc="-1" strike="noStrike">
              <a:solidFill>
                <a:srgbClr val="000000"/>
              </a:solidFill>
              <a:latin typeface="Arial"/>
            </a:endParaRPr>
          </a:p>
          <a:p>
            <a:pPr lvl="5" marL="9393120" indent="-1042920">
              <a:spcBef>
                <a:spcPts val="3651"/>
              </a:spcBef>
              <a:buClr>
                <a:srgbClr val="000000"/>
              </a:buClr>
              <a:buFont typeface="Arial"/>
              <a:buChar char="»"/>
              <a:tabLst>
                <a:tab algn="l" pos="4175280"/>
                <a:tab algn="l" pos="8350200"/>
              </a:tabLst>
            </a:pPr>
            <a:r>
              <a:rPr b="0" lang="en-US" sz="146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14600" spc="-1" strike="noStrike">
              <a:solidFill>
                <a:srgbClr val="000000"/>
              </a:solidFill>
              <a:latin typeface="Arial"/>
            </a:endParaRPr>
          </a:p>
          <a:p>
            <a:pPr lvl="6" marL="9393120" indent="-1042920">
              <a:spcBef>
                <a:spcPts val="3651"/>
              </a:spcBef>
              <a:buClr>
                <a:srgbClr val="000000"/>
              </a:buClr>
              <a:buFont typeface="Arial"/>
              <a:buChar char="»"/>
              <a:tabLst>
                <a:tab algn="l" pos="4175280"/>
                <a:tab algn="l" pos="8350200"/>
              </a:tabLst>
            </a:pPr>
            <a:r>
              <a:rPr b="0" lang="en-US" sz="146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14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2285640" y="27562320"/>
            <a:ext cx="10667880" cy="2101680"/>
          </a:xfrm>
          <a:prstGeom prst="rect">
            <a:avLst/>
          </a:prstGeom>
          <a:noFill/>
          <a:ln w="0">
            <a:noFill/>
          </a:ln>
        </p:spPr>
        <p:txBody>
          <a:bodyPr lIns="417600" rIns="417600" tIns="208800" bIns="208800" anchor="t">
            <a:noAutofit/>
          </a:bodyPr>
          <a:lstStyle>
            <a:lvl1pPr indent="0">
              <a:buNone/>
              <a:tabLst>
                <a:tab algn="l" pos="0"/>
                <a:tab algn="l" pos="4175280"/>
                <a:tab algn="l" pos="8350200"/>
              </a:tabLst>
              <a:defRPr b="0" lang="en-US" sz="6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4175280"/>
                <a:tab algn="l" pos="8350200"/>
              </a:tabLst>
            </a:pPr>
            <a:r>
              <a:rPr b="0" lang="en-US" sz="6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6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15621120" y="27562320"/>
            <a:ext cx="14477760" cy="2101680"/>
          </a:xfrm>
          <a:prstGeom prst="rect">
            <a:avLst/>
          </a:prstGeom>
          <a:noFill/>
          <a:ln w="0">
            <a:noFill/>
          </a:ln>
        </p:spPr>
        <p:txBody>
          <a:bodyPr lIns="417600" rIns="417600" tIns="208800" bIns="208800" anchor="t">
            <a:noAutofit/>
          </a:bodyPr>
          <a:lstStyle>
            <a:lvl1pPr indent="0" algn="ctr">
              <a:buNone/>
              <a:tabLst>
                <a:tab algn="l" pos="0"/>
                <a:tab algn="l" pos="4175280"/>
                <a:tab algn="l" pos="8350200"/>
              </a:tabLst>
              <a:defRPr b="0" lang="en-US" sz="6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4175280"/>
                <a:tab algn="l" pos="8350200"/>
              </a:tabLst>
            </a:pPr>
            <a:r>
              <a:rPr b="0" lang="en-US" sz="6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6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32765760" y="27562320"/>
            <a:ext cx="10667880" cy="2101680"/>
          </a:xfrm>
          <a:prstGeom prst="rect">
            <a:avLst/>
          </a:prstGeom>
          <a:noFill/>
          <a:ln w="0">
            <a:noFill/>
          </a:ln>
        </p:spPr>
        <p:txBody>
          <a:bodyPr lIns="417600" rIns="417600" tIns="208800" bIns="208800" anchor="t">
            <a:noAutofit/>
          </a:bodyPr>
          <a:lstStyle>
            <a:lvl1pPr indent="0" algn="r">
              <a:buNone/>
              <a:tabLst>
                <a:tab algn="l" pos="0"/>
                <a:tab algn="l" pos="4175280"/>
                <a:tab algn="l" pos="8350200"/>
              </a:tabLst>
              <a:defRPr b="0" lang="en-US" sz="6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4175280"/>
                <a:tab algn="l" pos="8350200"/>
              </a:tabLst>
            </a:pPr>
            <a:fld id="{759708D9-8142-4F4C-BF75-D4401AAD4415}" type="slidenum">
              <a:rPr b="0" lang="en-US" sz="6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6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2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409680" y="2103480"/>
            <a:ext cx="45005400" cy="24829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175280"/>
                <a:tab algn="l" pos="83502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175280"/>
                <a:tab algn="l" pos="83502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ourier New"/>
              </a:rPr>
              <a:t>Cint_PDE4   FDVENGLA--PARSPVDAQASP--G-MILHSTAVPHSQRRESFLYRSDSEFDQSSPKIGSRNSSVVSDMHGIEDLIVTPFAQ---------VLASLRRVRNDFIMLTNINPPTNNKSPSSQGKMSSNSSPTIPVNQQGNVVPGTEEFVQRAVNTVEELDWCLEQLDAVQTHRSVSEMASNKFKRMLNKELNQLSGMSKSGNQVSEFISTIFLDNQNDVMSPNHDPTDDREKRPASPNCGAIGKTTKSHLNPAGRIMGDITGIKQMNRHRDTISRWRKLPMYGVVVSNEEALAKELEDIDTWGGVDLFKIAEISNNRPLTSIMYTICKKRDMFVKFKLSPVKFLTYMMTLEDHYR-KVPYHNSLHAADVTQSVHVLLSSAALDSVFTDLEVLAALVASAMHDVDHPGLNNQYHCANSTELAIMYNDECVLENHHLAVGFKLMQQDHCDVFEHFTQKQWQSLRKMAIDMVL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175280"/>
                <a:tab algn="l" pos="83502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ourier New"/>
              </a:rPr>
              <a:t>Hsap_PDE4A  FEAENGPTPSPGRSPLDSQASP--G-LVLHAGAAT-SQRRESFLYRSDSDYDMS-PKTMSRNSSVTSE-AHAEDLIVTPFAQ---------VLASLRSVRSNFSLLTNVPVPSNKRSPLGG-PTP------VCKA-----TLSEETCQQLARETLEELDWCLEQLETMQTYRSVSEMASHKFKRMLNRELTHLSEMSRSGNQVSEYISTTFLDKQNEVEIPSPTMKEREKQQAPRPRPSQPPPPPVPHLQPMSQITG-----LKKLMHSNSLN-NSNIPRFGVKTDQEELLAQELENLNKWG-LNIFCVSDYAGGRSLTCIMYMIFQERDLLKKFRIPVDTMVTYMLTLEDHYHADVAYHNSLHAADVLQSTHVLLATPALDAVFTDLEILAALFAAAIHDVDHPGVSNQFLINTNSELALMYNDESVLENHHLAVGFKLLQEDNCDIFQNLSKRQRQSLRKMVIDMVL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175280"/>
                <a:tab algn="l" pos="83502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ourier New"/>
              </a:rPr>
              <a:t>Cjac_PDE4A  FDAENGPTPSPGRSPLDSQASP--G-LVLHAGAAT-SQRRESFLYRSDSDYDMS-PKTMSRNSSVTSE-AHAEDLIVTPFAQ---------VLASLRSVRSNFSLLTNVPVPSNNGSPLG---PT-----PVCKA-----TLSE-TCQHMYRETLEELDWRLEQKEPKQSYRSVSEMSSHK-KR--------------------------MLNKQNEVEIPSPTMKEREKQRVPRPRPSQPPPPPVPHLQPMSQITG-----VKKLMHSDSLN-DSNIPRFGVKTDQEELLAQELENLNKWG-LNIFCVSDYAGGRSLTCIMYMIFQERDLLKKFRIPVDTMVTYMLTLEDHYHADVAYHNSLHAADVLQSTHVLLATPALDAVFTDLEILAALFAAAIHDVDHPGVSNQFLINTNSELALMYNDESVLENHHLAVGFKLLQEDNCDIFQNLSKRQRQSLRKMVIDMVL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175280"/>
                <a:tab algn="l" pos="83502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ourier New"/>
              </a:rPr>
              <a:t>Mmus_PDE4A  LEAENGPTPSPGRSPLDSQASP--G-LMLHAGAAT-SQRRESFLYRSDSDYDMS-PKTMSRNSSVASE-AHGEDLIVTPFAQ---------VLASLRNVRSNFSLLTNVPIPSNKRSPLGG-PPS------VCKA-----TLSEETCQQLARETLEELDWCLEQLETMQTYRSVSEMASHKFKRMLNRELTHLSEMSRSGNQVSEYISNTFLDKQHEVEIPSPTPRQRPFQ--------QPPPAAVQQAQPMSQITG-----LKKLVHTGSLN--INVPRFGVKTDQEDLLAQELENLSKWG-LNIFCVSEYAGGRSLSCIMYTIFQERDLLKKFHIPVDTMMTYMLTLEDHYHADVAYHNSLHAADVLQSTHVLLATPALDAVFTDLEILAALFAAAIHDVDHPGVSNQFLINTNSELALMYNDESVLENHHLAVGFKLLQEENCDIFQNLSKRQRQSLRKMVIDMVL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175280"/>
                <a:tab algn="l" pos="83502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ourier New"/>
              </a:rPr>
              <a:t>Rnor_PDE4A  LEAENGPTPSPGRSPLDSQASP--G-LVLHAGATT-SQRRESFLYRSDSDYDMS-PKAVSRSSSVASE-AHAEDLIVTPFAQ---------VLASLRSVRSNFSLLTNVPIPSNKRSPLGG-PPS------VCKA-----TLSEETCQQLARETLEELDWCLEQLETMQTYRSVSEMASHKFKRMLNRELTHLSEMSRSGNQVSEYISNTFLDKQNEVEIPSPTPRQRAFQ--------QPPPSVLRQSQPMSQITG-----LKKLVHTGSLN--TNVPRFGVKTDQEDLLAQELENLSKWG-LNIFCVSEYAGGRSLSCIMYTIFQERDLLKKFHIPVDTMMMYMLTLEDHYHADVAYHNSLHAADVLQSTHVLLATPALDAVFTDLEILAALFAAAIHDVDHPGVSNQFLINTNSELALMYNDESVLENHHLAVGFKLLQEENCDIFQNLSKRQRQSLRKMVIDMVL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175280"/>
                <a:tab algn="l" pos="83502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ourier New"/>
              </a:rPr>
              <a:t>Cfam_PDE4A  FEAENGPTPSPGRSPLDSQASP--G-LVLHAGAAA-SQRRESFLYRSDSDYDMS-PKTMSRNSSVTSE-AHAEDLIVTPFAQ---------VLASLRSVRSNFSLLTNVPIPSNKRSPLGG-PTP------VCKA-----TLSEETCQQLARETLEELDWCLEQLETMQTYRSVSEMASHKFKRMLNRELTHLSEMSRSGNQVSEYISTTFLDKQNEVEIPSPTMKDREKQPAPRQRPSQQPPPPGPQFQPMSQITG-----VKKLMHSSSLN-DSSIPRFGVKTDQEELLAQELENLNKWG-LNIFCVSEYAGGRSLSCIMYTIFQERDLLKKFRIPVDTMVTYMLTLEDHYHPDVAYHNSLHAADVLQSTHVLLATPALDAVFTDLEILAALFAAAIHDVDHPGVSNQFLINTNSELALMYNDESVLENHHLAVGFKLLQEDNCDIFQNLSKRQRQSLRKMVIDMVL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175280"/>
                <a:tab algn="l" pos="83502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ourier New"/>
              </a:rPr>
              <a:t>Btau_PDE4A  LEAENGPTPSPGRSPLDSQASP--G-LVLHAGAAT-SQRRESFLYRSDSDYDMS-PKTMSRNSSVTSE-AHAEDLIVTPFAQ---------VLASLRSVRSNFSLLTNVPIPSNKRSPLGG-PTP------VCKA-----TLSEETCQQLARETLEELDWCLEQLETMQTYRSVSEMASHKFKRMLNRELTHLSEMSRSGNQVSEYISTTFLDKRNEVEIPSPTIKDREKQQAPRQRPCQQPPAPGPQLQPMSQITG-----VKKLMHSSSLN-DSSMPRFGVKTDQEERLAQELENLNKWG-LNIFRVSDYAGGRSLSCIMYTIFQERDLLKKFRIPVDTMVTYMLTLEDHYHPDVAYHNSLHAADVLQSTHVLLATPALDAVFTDLEILAALFAAAIHDVDHPGVSNQFLINTNSELALMYNDESVLENHHLAVGFKLLQEDNCDIFQNLGKRQRQSLRKMVIDMVL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175280"/>
                <a:tab algn="l" pos="83502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ourier New"/>
              </a:rPr>
              <a:t>Sscr_PDE4A  FEAENGPTPSPGRSPLDSQASP--G-LVLHAGVAT-SQRRESFLYRSDSDYDMS-PKTMSRNSSVTSE-AHAEDLIVTPFAQ---------VLASLRSVRSNFSLLTNVPIPSNKRSPLGG-PTP------VCKA-----TLSEETCQQLARETLEELDWCLEQLETMQTYRSVSEMASHKFKRMLNRELTHLSEMSRSGNQVSEYISTTFLDKQNEVDIPSPTMKDHEKQQAPRQRPSQQPPPPGPQFQPMSQITG-----VKKLMHSSSLNEDSSIPRFGVKTDQEELLAQELENLNKWG-LNIFCVSDYAGGRSLSCIMYTIFQERDLLKKFRIPVDTMVTYMLTLEDHYHPDVAYHNSLHAADVLQSTHVLLATPALDAVFTDLEILAALFAAAIHDVDHPGVSNQFLINTNSELALMYNDESVLENHHLAVGFKLLQEDNCDIFQNLSKRQRQSLRKMVIDMVL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175280"/>
                <a:tab algn="l" pos="83502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ourier New"/>
              </a:rPr>
              <a:t>Mdom_PDE4A  IEMENGPSPSPGRSPLDSQASP--G-LVLPPSAPH-SQRRESFLYRSDSDYDMS-PKTMSRNSSIASE--VHEDLIVTPFAQ---------VLASLRSVRSNFSLLANVPAIVGNKKSPMGNQP------AVCKA-----TLSEETYQQLARETLEELDWCLEQLETMQTYRSVSEMASHKFKRMLNRELTHLSEMSRSGNQVSEYISTTFLDKQADVEIPPPTPKEQEKQLQQRPQ-----------RQPMSQISG-----VKKLTHSSSLS-NSGIPQFGVKTDQEELLGKELENLNKWG-LNIFRVAEFSNGRSLGCIMYTIFQERDLLKTFQIPVDTLVTYMLTLEDHYHADVAYHNSLHAADVLQSTHVLLATPALDAVFTDLEILAALFAAAIHDVDHPGVSNQFLINTNSELALMYNDESVLENHHLAVGFKLLQEENCDIFQNLNKRQRQSLRRMVIDMVL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175280"/>
                <a:tab algn="l" pos="83502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ourier New"/>
              </a:rPr>
              <a:t>Acar_PDE4A  FEIENGPSP--GRSPLDSQASP--G-LVLHPSFPQ-SQRRESFLYRSDSDYDMS-PKTMSRNSSVASE-AHTEDLIVTPFAQ---------VLASLRSVRNNFSILANVPTPTSNKRSPMGSQPT------VCKA-----TLSEETYQQMAKETLEELDWCLDQLETIQTYRSVSEMASNKVGASISREESHLSPLSPLSLRCSLFSSS---DKQNDVEIPSPTQKEREKKKRQQ---------------PMCQISG-----VKKLMHSSSLT-NSSIPRFGVKTDQEDLLNKELDYLNKWG-LNIFRVAEYSNNRSLSCIMYTIFQERDLLKTFKIPVDTLVTYIMTLEDHYHADVAYHNSLHAADVTQSTHVLLSTPALDAVFTDLEILAAIFAAAIHDVDHPGVSNQFLINTNSELALMYNDESVLENHHLAVGFKLLQEENCDIFQNLTKRQRQTLRKMVIDMVL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175280"/>
                <a:tab algn="l" pos="83502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ourier New"/>
              </a:rPr>
              <a:t>Xlae_PDE4A  FDVENGPSP--GRSPIDSQASP--G-LVLHPNFPQ-SQRRESFLYRSDSDYDMS-PKTMSRNSSVTSE-VHTEDLIVTPFAQ---------VLASLRSVRNNFTVLANVTTP-TK-RSPVMPQQT------VCKA-----TLSEETYQQLAKETLEELDWCLDQLESMQTYRSVSEMASNKFKRMLNRELTHLSEMSRSGNQVSEYISNTFLDKQNEVEIPSPTQKEREKKKK---------------QQPMCQISG-----VKKLMHSSSLT-NSTIPRFGVKTDQEEVLCKELDNLNKWG-LNIFRVAEYSNNRPLSCIMYTVFQERELLKTFQIPVDTLMTYMMTLEDHYHADVAYHNSLHAADVTQSTHVLLSTPALDAVFTDLEILAALFAAAIHDVDHPGVSNQFLINTNSELALMYNDESVLENHHLAVGFKLLQEENCDIFQNLPKRQRQMMRKMVIDMVL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175280"/>
                <a:tab algn="l" pos="83502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ourier New"/>
              </a:rPr>
              <a:t>Gacu_PDE4A1 FDSENGPSP--GRSPMDSQASP--G-LVVHPSFPQ-SQRRESFLYRSDSDFDTS-PKTMSRNSSINSE-RHAEDMIVTPFAQ---------VRFRLRTVRSNFTILAVTTP--TNKRSPVTSQPT------VPQA-----TLSEETYQQMALETLEELDWCLDQLETIQTHRSVSEMASNKFKRMLNRELSHLSEMSRSGNQVSEYISTTFLDKQNEVEIPSPTSRER--------------------EKPMCHISG-----VKKLTHSSSLS-NSITPRFGVKTEHEDQLARELNDLNIWG-LNIFRVAEYSNNRPLSCTMFAIFQERDLLKTFRIPVDTFVTYVMTLEDHYHANVAYHNSLHAADVTQSTHVLLSTPALDAVFTDLEILAALFAAAIHDVDHPGVSNQFLINTNSELALMYNDESVLENHHLAVGFKLLHEENCDIFQNLSKRQRQSLRKLVIDMVL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175280"/>
                <a:tab algn="l" pos="83502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ourier New"/>
              </a:rPr>
              <a:t>Gacu_PDE4A2 YEAENGVSP--GHTPLGSHSPG----LALHTPFAP-GQRRESFLYRSDSDYDMS-PKTVSRNSSLASEGHVGEDFIVTPFAQ---------VLASLRSVRSNFTILANVSTP-PIKRSPLAGVCV-------SPRA----ALSDQQYQQLALDTLEELDWCLDQLETIQTHRSVSEMASTKFKRMLNRELSHLSEMSRSGNQVSEYISSTFMDKQNDVEIPSPTLK----------------------EKSMSHISG-----VRKLSHSSSLS-SSSMPRFGVNTEHEDELAKELEDLDKWS-FNIFRVAEFSNNRPLSCIMYTIFQERELLKTFRIPVETFVTYVMTLEDHYHENIPYHNSLHAADVAQSTHVLLSTPALDAVFTDLEILAALFAAAIHDVDHPGVSNQFLINTNSELALMYNDESVLENHHLAVGFKLVHQENCDIFQNLTKRQRQSLRKLVIDMVL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175280"/>
                <a:tab algn="l" pos="83502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ourier New"/>
              </a:rPr>
              <a:t>Trub_PDE4A1 FDVENGPSP--GRSPIDSQASP--G-LVLHPSFPQ-SQRRESFLYRSDSDYDMS-PKTMSRNSSVTSE-AHAEDLIVTPFAQ---------VLASLRSVRNNFTILANVTTP-TNKRSPVMPQQT------VCKA-----TLSEETYQQLAKETLEELDWCLDQLETMQTYRSVSEMASNKFKRMLNRELTHLSEMSRSGNQVSEYISNTFLDKQNEVDIPSPTQKEREKKKK---------------QQPMCQISG-----VKKLMHSSSLT-NSAIPRFGVKTDQEESLGKELDNLNKWG-LNIFRVAEYSNNRPLSCTMYTVFQERELLKTFKIPVDTLMTYMMTLEDHYHADVAYHNSLHAADVTQSTHVLLSTPALDAVFTDLEILAALFAAAIHDVDHPGVSNQFLINTNSELALMYNDESVLENHHLAVGFKLLQEENCDIFQNLTKRQRQTMRKMVIDMVL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175280"/>
                <a:tab algn="l" pos="83502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ourier New"/>
              </a:rPr>
              <a:t>Trub_PDE4A2 YEAENGVSP--GHTPLGSQSPG----LTLHTSLQ--GQRRESFLYRSDSDYDMS-PKTVSRNS-LASEGHTAEDFIVTPFAQ---------VLASLRSVRSNFTILANVSTP-TVKRSPMTGVCV-------SPRA----TLSDQQYQQLALDTLEELDWCLDQLETIQTHRSVSEMASNKFKRMLNRELSHLSEMSRSGNQVSEYISSTFLDKQNEVEIPSPTLK----------------------DKSMSHISG-----VRKLSHSSSLS-STSMPRFGVNTDHEDELAKELEDLDKWS-FNIFKVAEFSNNRPLSCIMYAIFQERELLKTFRIPVDTFVTYVMTLEDHYHSNVAYHNSLHAADVTQSTHVLLSTPALDAVFTDLEVLAALFAAAIHDVDHPGVSNQFLINTNSELALMYNDESVLENHHLAVGFKLLHQENCDIFQNLTKRQRQSLRKLVIDIVL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175280"/>
                <a:tab algn="l" pos="83502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ourier New"/>
              </a:rPr>
              <a:t>Olat_PDE4A2 YEAENGVSS--GHTPLGSQSPS----LTLHSSFTQ-GQRRESFLYRSDSDYDMS-PKTVSRNSSLASEGHTAEDFIVTPFAQ---------VLASLRSVRSNFTILANVTTP-TIKRSPLGGMCV------SPRP-----TLSDQQYHQLALDTLEELDWCLDQLETIQTHRSVSEMASTKFKRMLNRELSHLSEMSRSGNQVSEYISSTFMDKQNEVEIPSPTLK----------------------EKSMSHISG-----VRKLSHSSSLS-SASMPRFGVNTDHEDELAKELEDLDKWS-FNVFKVAEYSNNRPLSCIMYAIFQERELLKTFRIPVDTFVTYVMTLEDHYHGNVAYHNSLHAADVTQSTHVLLSTPALNAAFTDLEILAALFAAAIHDVDHPGVSNQFLINTNSELALMYNDESVLENHHLAVGFKLLHQENCDIFQNLTKRQRQSLRKLVIEMVL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175280"/>
                <a:tab algn="l" pos="83502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ourier New"/>
              </a:rPr>
              <a:t>Drer_PDE4A  YDGENGPSP--GRSPMDSQASP--G-LVLHPSFPQ-SQRRESFLYRSDSDYDMS-PKTMSRNSSINSE-GHAEDLIVTPFAQ---------VLASLRTVRSNFTILANVTTPTTTMRSPVTSQPT------VPPA-----TLSDETYQQLARETLEELDWCLDQLETIQTHRSVSEMASNKFKRMLNRELSHLSEMSRSGNQVSEYISTTFLDKQNEVEIPSPTLRER--------------------EKPMSHISG-----VKKLTHSSSLT-SAALPRFGVKTEQEDALARELNDLNKWG-LNIFHVAEFSNNRPLSCIMFAIFQERDLLKTFRIPVDTFITYVMTLEDHYHANVAYHNSLHAADVTQSTHVLLSTPALDAVFSDLEILAALFAAAIHDVDHPGVSNQFLINTNSELALMYNDESVLENHHLAVGFKLLHEENCDIFQNLTKRQRQSLRKLVIDMVL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175280"/>
                <a:tab algn="l" pos="83502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ourier New"/>
              </a:rPr>
              <a:t>Hsap_PDE4B  FDVENGPSP--GRSPLDPQASSSAG-LVLHATFPGHSQRRESFLYRSDSDYDLS-PKAMSRNSSLPSE-QHGDDLIVTPFAQ---------VLASLRSVRNNFTILTNLHGTSNKRSPAAS-QPP------VSRV-----NPQEESYQKLAMETLEELDWCLDQLETIQTYRSVSEMASNKFKRMLNRELTHLSEMSRSGNQVSEYISNTFLDKQNDVEIPSPTQKDREKKKK---------------QQLMTQISG-----VKKLMHSSSLN-NTSISRFGVNTENEDHLAKELEDLNKWG-LNIFNVAGYSHNRPLTCIMYAIFQERDLLKTFRISSDTFITYMMTLEDHYHSDVAYHNSLHAADVAQSTHVLLSTPALDAVFTDLEILAAIFAAAIHDVDHPGVSNQFLINTNSELALMYNDESVLENHHLAVGFKLLQEEHCDIFMNLTKKQRQTLRKMVIDMVL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175280"/>
                <a:tab algn="l" pos="83502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ourier New"/>
              </a:rPr>
              <a:t>Cjac_PDE4B  FDVENGPSP--GRSPLDPQASSSSG-LVLHTTFPGHSQRRESFLYRSDSDYDLS-PKAMSRNSSLPSE-QHGDDLIVTPFAQ---------VLASLRSVRNNFTILTNLHGTSNKRSPAAS-QPP------VSRV-----NPQEESYQKLAMETLEELDWCLDQLETIQTYRSVSEMASNKFKRMLNRELTHLSEMSRSGNQVSEYISNTFLDKQNDVEIPSPTQKDREKKKK---------------QQLMTQISG-----VKKLMHSSSLN-NTSISRFGVNTENEDHLAKELEDLNKWG-LNIFNVAGYSHNRPLTCIMYAIFQERDLLKTFRISSDTFITYMMTLEDHYHSDVAYHNSLHAADVAQSTHVLLSTPALDAVFTDLEILAAIFAAAIHDVDHPGVSNQFLINTNSELALMYNDESVLENHHLAVGFKLLQEEHCDIFMNLTKKQRQTLRKMVIDMVL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175280"/>
                <a:tab algn="l" pos="83502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ourier New"/>
              </a:rPr>
              <a:t>Mmus_PDE4B  FDVENGPSP--GRSPLDPQAGSSSG-LVLHAAFPGHSQRRESFLYRSDSDYDLS-PKAMSRNSSLPSE-QHGDDLIVTPFAQ---------VLASLRSVRNNFTLLTNLHGAPNKRSPAAS-QAP------VSRV-----SLQEESYQKLAMETLEELDWCLDQLETIQTYRSVSEMASNKFKRMLNRELTHLSEMSRSGNQVSEYISNTFLDKQNDVEIPSPTQKDREKKKK---------------QQLMTQISG-----VKKLMHSSSLN-NTSISRFGVNTENEDHLAKELEDLNKWG-LNIFNVAGYSHNRPLTCIMYAIFQERDLLKTFKISSDTFVTYMMTLEDHYHSDVAYHNSLHAADVAQSTHVLLSTPALDAVFTDLEILAAIFAAAIHDVDHPGVSNQFLINTNSELALMYNDESVLENHHLAVGFKLLQEEHCDIFQNLTKKQRQTLRKMVIDMVL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175280"/>
                <a:tab algn="l" pos="83502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ourier New"/>
              </a:rPr>
              <a:t>Rnor_PDE4B  FDVENGPSP--GRSPLDPQASSSSG-LVLHAAFPGHSQRRESFLYRSDSDYDLS-PKAMSRNSSLPSE-QHGDDLIVTPFAQ---------VLASLRIVRNNFTLLTNLHGAPNKRSPAAS-QAP------VTRV-----SLQEESYQKLAMETLEELDWCLDQLETIQTYRSVSEMASNKFKRMLNRELTHLSEMSRSGNQVSEYISNTFLDKQNDVEIPSPTQKDREKKKK---------------QQLMTQISG-----VKKLMHSSSLN-NTSISRFGVNTENEDHLAKELEDLNKWG-LNIFNVAGYSHNRPLTCIMYAIFQERDLLKTFKISSDTFVTYMMTLEDHYHSDVAYHNSLHAADVAQSTHVLLSTPALDAVFTDLEILAAIFAAAIHDVDHPGVSNQFLINTNSELALMYNDESVLENHHLAVGFKLLQEEHCDIFQNLTKKQRQTLRKMVIDMVL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175280"/>
                <a:tab algn="l" pos="83502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ourier New"/>
              </a:rPr>
              <a:t>Cfam_PDE4B  FDVENGPSP--GRSPLDPQASSSSG-LVLHATFPGHSQRRESFLYRSDSDYDLS-PKAMSRNSSLPSE-QHGDDLIVTPFAQ---------VLASLRSVRNNFTVLTNLHGASNKRSPAATSQPP------VSRV-----NLQEESYQKLAMETLEELDWCLDQLETIQTYRSVSEMASNKFKRMLNRELTHLSEMSRSGNQVSEYISNTFLDKQNDVEIPSPTQKDREKKKK---------------QQLMTQISG-----VKKLMHSSSLN-NTSISRFGVNTENEDHLAKELEDLNKWG-LNIFNVAGYSHNRPLTCIMYAIFQERDLLKTFKISSDTFVTYMMTLEDHYHSDVAYHNSLHAADVAQSTHVLLSTPALDAVFTDLEILATIFAAAIHDVDHPGVSNQFLINTNSELALMYNDESVLENHHLAVGFKLLQEEHCDIFQNLTKKQRQTLRKMVIDMVL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175280"/>
                <a:tab algn="l" pos="83502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ourier New"/>
              </a:rPr>
              <a:t>Ecab_PDE4B  FDVENGPSP--GRSPLDPQASSSSG-LVLHATFPGHSQRRESFLYRSDSDYDLS-PKAMSRNSSLPSE-QHGDDLIVTPFAQ---------VLASLRSVRNNFTILTNLHGTSNKRSPAAS-QPP------VSRV-----HLQEESYQKLAMETLEELDWCLDQLETIQTYRSVSEMASNKFKRMLNRELTHLSEMSRSGNQVSEYISNTFLDKQNDVEIPSPTQKDREKKKK---------------QQLMTQISG-----VKKLMHSSSLN-NTSISRFGVNTENEDHLAKELEDLNKWG-LNIFNVAGYSHNRPLTCIMYAIFQERDLLKTFKISSDTFVTYMMTLEDHYHSDVAYHNSLHAADVAQSTHVLLSTPALDAVFTDLEILAAIFAAAIHDVDHPGVSNQFLINTNSELALMYNDESVLENHHLAVGFKLLQEEHCDIFQNLTKKQRQTLRKMVIDMVL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175280"/>
                <a:tab algn="l" pos="83502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ourier New"/>
              </a:rPr>
              <a:t>Btau_PDE4B  FDVENGPSP--GRSPLDPQASSSSG-LVLHATFPGHSQRRESFLYRSDSDYDLS-PKAMSRNSSLPSE-QHGDDLIVTPFAQ---------VLASLRSVRNNFTLLTNLHGTSNKRSPAAG-QPS------VSRV-----NLPEESYQKLAMETLEELDWCLDQLETIQTYRSVSEMASNKFKRMLNRELTHLSEMSRSGNQVSEYISNTFLDKQNDVEIPSPTQKDREKKKK---------------QQLMTQISG-----VKKLMHSSSLN-NTSISRFGVNTENEDHLAKELEDLNKWG-LNIFNVAGYSHNRPLTCIMYAIFQERDLLKTFKISSDTFVTYMMTLEDHYHADVAYHNSLHAADVAQSTHVLLSTPALDAVFTDLEILAAIFAAAIHDVDHPGVSNQFLINTNSELALMYNDESVLENHHLAVGFKLLQEEHCDIFQNLTKKQRQTLRKMVIDMVL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175280"/>
                <a:tab algn="l" pos="83502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ourier New"/>
              </a:rPr>
              <a:t>Sscr_PDE4B  FDVENGPSP--GRSPLDPQASSSSG-LVLHATFPGHSQRRESFLYRSDSDYDLS-PKAMSRNSSLPSE-QHGDDLIVTPFAQ---------VLASLRSVRNNFTVLTNLHGTSNKRSPAAS-QPP------VSRV-----NLPEESYQKLAMETLEELDWCLDQLETIQTYRSVSEMASNKFKRMLNRELTHLSEMSRSGNQVSEYISNTFLDKQNDVEIPSPTQKDREKKKK---------------QQLMTQISG-----VKKLMHSSSLN-NTSISRFGVNTENEDHLAKELEDLNKWG-LNIFNVAGYSHNRPLTCIMYAIFQERDLLKTFKISSDTLVTYMMTFEDHYHSDVAYHNSLHAADVAQSTHVLLSTPALDAVFTDLEILAAIFAAAIHDVDHPGVSNQFLINTNSELALMYNDESVLENHHLAVGFKLLQEEHCDIFQNLTKKQRQTLRKMVIDMVL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175280"/>
                <a:tab algn="l" pos="83502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ourier New"/>
              </a:rPr>
              <a:t>Mdom_PDE4B  FDVENGPSP--GRSPLDPQAGSSSG-LVLHTTFPGHSQRRESFLYRSDSDYDLS-PKAMSRNSSLPSE-QHGDDLIVTPFAQ---------VLASLRSVRNNFTILTNLHGAVNKRSPAAT-QPP------VSRV-----NLQEESYQRLAMETLEELDWCLDQLETIQTYRSVSEMASNKFKRMLNRELTHLSEMSRSGNQVSEYISNTFLDKQNEVEIPSPTQKDREKKKKE--------------QQVMTQISG-----VKKLMHSSSLN-NTSISRFGVKTEKEDHLAKELEDLNKWG-LNIFKVAGYSHNRPLTCIMYAIFQERDLLKTFKISSDTFVTYMMTLEDHYHSDVAYHNSLHAADVAQSTHVLLSTPALDAVFTDLEILAAIFAAAIHDVDHPGVSNQFLINTNSELALMYNDESVLENHHLAVGFKLLQEEHCDIFQNLTKKQRQTLRKMVIDMVL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175280"/>
                <a:tab algn="l" pos="83502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ourier New"/>
              </a:rPr>
              <a:t>Xlae_PDE4B  FDVENGPTP--GRSPLDHQASPGSG-LVLHTNFTSHNQRRESFLYRSDSDYDLS-PKTMSRNSSAASE-QHGDDLIVTPFAQ---------VLASLRSVRNNFTVLTNVHGVPNKRSPMTS-QPQ------ISRV-----NHQEDSYQKIAMDTLEELDWCLDQLETIQTYRSVSEMASNKFKRMLNRELTHLSEMSRSGNQVSEYISSTFLDKQNDVEIPSPTQKDREKKKK---------------QQLMTQISG-----VKKLKHSSSLN-NTSMSRFGVKTDYEDMLSKELEDLNKWG-LNIFKVASYSCNRPLTCIMYAIFQERDLLKTFKIPVDTLITYTMTLEDHYHSDVAYHNSLHAADVTQSTHVLLSTPALDAVFTDLEILAAIFAAAIHDVDHPGVSNQFLINTNSELALMYNDESVLENHHLAVGFKLLQEEHCDIFQNLTKKQRQSLRKMVIDLVL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175280"/>
                <a:tab algn="l" pos="83502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ourier New"/>
              </a:rPr>
              <a:t>Gacu_PDE4B2 FDVENGPSV--GCSPLDPQASPGSG-LVLHTNFPGHNQRRESFLYRSDSDYDLS-PKSMSRNSSIASE-LHGDDLIVTPFAQ---------VLASLRSVRNNFTALTNVQCASSKRSPAATTQPP------ITRV-----CLPDEAFQKLAMETMEELDWCLDQLETIQTYRSVSDMASNKFKRMLNRELTHLSEMSRSGNQVSEFISNTFLDKQNEVEIPSPTSKTREKKKQQ----------------LMTQISG-----VKKVSHGPSLS-GSSISRFGVKTDKEELLAKELEDLNKWG-LNIFTVSEYSHNRPLTCIMYAIFQERDLLKTFQIPVDTFVAYMMTLEDHYHSDVAYHNSLHAADVAQSTHILLSTPALDAVFTDLEILAAIFAAAIHDVDHPGVSNQFLINTNSELALMYNDESVLENHHLAVGFKLLQEDNCDIFQNLTKKQRQSLRKMAIDMVL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175280"/>
                <a:tab algn="l" pos="83502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ourier New"/>
              </a:rPr>
              <a:t>Gacu_PDE4B1 FEGENGPSL--CCSPSELQASPGSG-LVLHPNQAGHGQRRESFLYRSDSDYELS-PKSLSRNSSIVGE-LHGEDLIVTPFAQ---------VLASLRTVRNNFTTLTNVQCASNKRS-PATNQPT------LTKV-----CLSDDSYQKLAMETMEELDWCLDQLETIQTYRSVSDMASNKFKRMLNRELSHLSEMSRSGNQVSEYISNTFLEKQNELELPCPVPKSRERKRRQG---------------MMTQISG-----VRKVSHTPSIC-ASTNNRFGVKTDQEELLSKDLEGINKWG-LNIFQVAEHSRNRPLTSIMYSIFQERDLMRTFKIPTDTFVTFMLTLEDHYHSDVAYHNSLHAADVAQSTHILLSTPALDEVFTDLEILAAIFAAAIHDVDHPGVSNQFLINTNSELALMYNDESVLENHHLAVGFKLLQGDNCDIFQNLTKKQKQTLRRMVIDMVL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175280"/>
                <a:tab algn="l" pos="83502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ourier New"/>
              </a:rPr>
              <a:t>Olat_PDE4B1 FEVENGPSL--CCSPSDPQASPGSG-LVLHPSLAAHGQRRESFLYRSDSDYELS-PKSLSRNSSIVGE-LHGEDLIVTPFAQ---------VLASLRTVRNNFTTLTNVQCTSNKRS-PASNQPC------STKV-----CLSDESYQKLAMETMEELDWCLDQLETIQTYRSVSDMASNKFKRMLNRELSHLSEMSRSGNQVSEYISNTFLDKQNELELPCPVQKSRERKRRQGQQQ---QP-----GGMMTQISG-----VKKVSNASSIT-GGSTNRFGVKTDQEELLSKDLEDINKWG-LNIFRVAEHSHNRPLTCIMYSIFQERDLMRTFKIPTDTFVTFMLTLESHYHSDVAYHNSLHAADVAQSTHILLSTPALDAVFTDLEILAAIFAAAIHDVDHPGVSNQFLINTNSELALMYNDESVLENHHLAVGFKLLQEENCDIFQNLTKKQKQTLRRMVIDMVL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175280"/>
                <a:tab algn="l" pos="83502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ourier New"/>
              </a:rPr>
              <a:t>Olat_PDE4B2 FDVENGPSA--SCSPLDPQASPGSG-LVLHTNFPGHNQRRESFLYRSDSDYELS-PKSMSRNSSIASE-LHGDDLIVTPFAQ---------VLASLRSVRNNFTVLTNVQCASSKRSPAATTQPP------ITRV-----CLPDEAYQKLAVETMEELDWCLDQLETIQTYRSVSDMASNKFKRMLNRELTHLSEMSRSGNQVSEFISNTFLDKQNDVEIPSPTSKAREKKKQQKQ-------------QLMTQISG-----VKKVSHGPLLS-SSSISRFGVKTDKEELLSKELEELNKWG-LNIFTVSEYSNNRPLTCIMYAIFQERDLLKTFKIPADTFVAYMMTLEDHYHSDVAYHNSLHAADVAQSTHILLSTPALDAVFTDLEILAAIFAAAIHDVDHPGVSNQFLINTNSELALMYNDESVLENHHLAVGFKLLQEDNCDIFQNLTKKQRQSLRKMVIDMVL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175280"/>
                <a:tab algn="l" pos="83502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ourier New"/>
              </a:rPr>
              <a:t>Trub_PDE4B1 FEGENGPSS--CCSPSDPQASPGSG-LALHPNQAAHGQRRESFLYRSDSDYELS-PKSLSRNSSIVGE-LHSEELIVTPFAQ---------VLASLRIVRNNFTTLTNVQCTSFKKS-PAANQPS------VTKV-----CLSDESYQKLAMETMEELDWCLDQLETIQTYRSVSDMASNKFKRMLNRELSHLSEMSRSGNQVSEYISNTFLDKQNELEVPCPVPKSRDRKRRQGQQQQQQQQ-----GGMMTQISG-----VRKVSHTSGVS-GGSGNRFGVKTDQEELLSKDLEDINKWG-LNIFRVAEHSHNRPLTCVMYTIFQERDLMRTFKIPADTFVTFMLTLESHYHSDVAYHNSLHAADVAQSTHILLSTPALDAVFTDLEILAAIFAAAIHDVDHPGVSNQFLINTNSELALMYNDESVLENHHLAVGFKLLQEDNCDIFQNLTKKQRQTLRRMVIDMVL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175280"/>
                <a:tab algn="l" pos="83502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ourier New"/>
              </a:rPr>
              <a:t>Trub_PDE4B2 FDVENGPSS--SCSPLDPQASPGSG-LVLHTNFPSHSQRRESFLYRSDSDYDLS-PKSMSRNSSIASE-LHGDDLIVTPFAQ---------VLASLRSVRNNFTVLTNVQCASSKRSPAATTQPP------FTRV-----CLPDEAYQKLAMETMEELDWCLDQLETIQTYRSVSDMASTKFKRMLNRELTHLSEMSRSGNQVSEFISNTFLDKQNEVEIPSPTSKTREKKKQQKQ-------------QLMTQISG-----VKKVSHGPSLS-SSSISRFGVKTDNEELLSKELENLNKWG-LNIFTVSEYSHNRPLTCIMYAIFQERDLLKTFKIPVDTFVAYMMTLEDHYHSDVAYHNSLHAADVAQSTHILLSTPALDAVFTDLEILAAIFAAAIHDVDHPGVSNQFLINTNSELALMYNDESVLENHHLAVGFKLLQEDNCDLFQNLTKKQRQSLRKMVIDMVL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175280"/>
                <a:tab algn="l" pos="83502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ourier New"/>
              </a:rPr>
              <a:t>Drer_PDE4B  FDVENGPSA--SCSPLDPQASPGSG-LVLHTNFPGHNQRRESFLYRSDSDYDLS-PKSMSRNSSVASE-LHGDDLIVTPFAQ---------VLASLRSVRNNFTVLTNVQCTSNKRSPVSN-QPS------ITRV-----CLPDESYQKLAVETMEELDWCLDQLETIQTYRSVSDMASNKFKRMLNRELTHLSEMSRSGNQVSEFISNTFLDKQNDVEIPSPTPKAREKKKKQ---------------QLMTQISG-----VKKVSHGPSLN-CG-IARFGVKTDKEDLLSKELEDLNRWG-LNIFTVSEYSNNRPLTCIMYAIFQERDLLKTFKIPTDTFVTYMMTLEDHYHQDVAYHNSLHAADVAQSTHILLSTPALDAVFTDLEILAAIFAAAIHDVDHPGVSNQFLINTNSELALMYNDESVLENHHLAVGFKLLQEDNCDIFQNLTKKQRTSLRRMVIDMVL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175280"/>
                <a:tab algn="l" pos="83502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ourier New"/>
              </a:rPr>
              <a:t>Hsap_PDE4C  FDLENGLSC--GRRALDPQSSPGLG-RIMQAPVPH-SQRRESFLYRSDSDYELS-PKAMSRNSSVASD-LHGEDMIVTPFAQ---------VLASLRTVRSNVAALARQQCLGAAKQGPVGNP------SSSNQL-----PPAEDTGQKLALETLDELDWCLDQLETLQTRHSVGEMASNKFKRILNRELTHLSETSRSGNQVSEYISRTFLDQQTEVELPKVTAE-EAPQ-------------------PMSRISG-----LHGLCHSASLS-SATVPRFGVQTDQEEQLAKELEDTNKWG-LDVFKVAELSGNRPLTAIIFSIFQERDLLKTFQIPADTLATYLLMLEGHYHANVAYHNSLHAADVAQSTHVLLATPALEAVFTDLEILAALFASAIHDVDHPGVSNQFLINTNSELALMYNDASVLENHHLAVGFKLLQAENCDIFQNLSAKQRLSLRRMVIDMVL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175280"/>
                <a:tab algn="l" pos="83502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ourier New"/>
              </a:rPr>
              <a:t>Cjac_PDE4C  FDLENGLSS--GRSALDPQSSPGLG-RVVQAPVHH-SQRRESFLYRSDSDYDLS-PKAMSRNSSVASD-LHGEDMIVTPFAQ---------VLASLRTVRSNVAVLAHQQCRGAAKQGPVGNL------STSHQPA----PPAEDTGQMLALETLDELDWCLDQLETLQTRHSVGEMASNKFKRILNRELTHLSETSRSGNQVSEYISQTFLDQQTEVELPTVTAE-EPPK-------------------PVSQISG-----LHGLCHSASLS-SATVPRFGVQTEQEELLAKELEDTNKWG-LDVFKVAELSGNRPLTAIIFSIFQRRDLLKTFQIPADTLATYLLLLEGHYHADVAYHNSLHAADVAQSTHVLLATPALEAVFTDLEVLAALFASAIHDVDHPGVSNQFLINTNSELALMYNDASVLENHHLAVGFKLLQAENCDIFQNLSTKQRLSLRRMVIDMVL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175280"/>
                <a:tab algn="l" pos="83502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ourier New"/>
              </a:rPr>
              <a:t>Mmus_PDE4C  FDLENGLPG--GKGLLDAQSGPSLG-RALQPPVHH-VQRRESFLYRSDSDHEPS-PKAVSRTSSAASD-LHGEDMIVTPFAQ---------VLASLRTVRNNVAALAHGPG-SATRQVLLGTP------PHSSQQA----APTEDSGLQLVQETLEELDWCLEQLETLQTRRSVGEMASNKFKRMLNRELSYLSETSRSGNQVSEYISQTFLDQQAEVELPQPPTE-DDPW-------------------PMAQITE-----LRRSSHTS-LP-TAAIPRFGVQTDQEEQLAKELEDTNKWG-LDVFKVAELSGNRPLTAVIFSVFQERDLLKTFQIPADTLLAYLLTLEGHYHSDVAYHNSMHAADVVQSAHVLLGTPALEAVFTDLEVLAAIFACAIHDVDHPGVSNQFLINTNSELALMYNDSSVLENHHLAVGFKLLQGENCDIFRNLSTKQRLSLRRMVIDMVL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175280"/>
                <a:tab algn="l" pos="83502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ourier New"/>
              </a:rPr>
              <a:t>Rnor_PDE4C  FDLENGLPS--GRGPLDAQSGSSLG-RALQPPVHH-GQRRESFLYRSDSDHEPS-PKAVSRTSSAASD-LHGEDMIVTPFAQ---------VLASLRTVRSNVAALAHGAG-SATRQALLGTP------PQSSQQA----APAEESGLQLAQETLEELDWCLEQLETLQTRRSVGEMASNKFKRMLNRELTHLSETSRSGNQVSEYISQTFLDQQAEVELPAPPTE-DHPW-------------------PMAQITG-----LRKSCHTS-LP-TAAIPRFGVQTDQEEQLAKELEDTNKWG-FDVFKVAELSGNRPLTAVIFSVLQERDLLKTFQIPADTLLRYLLTLEGHYHSNVAYHNSIHAADVVQSAHVLLGTPALEAVFTDLEVLAAIFACAIHDVDHPGVSNQFLINTNSELALMYNDSSVLENHHLAVGFKLLQGENCDIFQNLSTKQKLSLRRMVIDMVL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175280"/>
                <a:tab algn="l" pos="83502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ourier New"/>
              </a:rPr>
              <a:t>Cfam_PDE4C  FDLENGLSC--GRSTLDPQAGPGLG-RVIQASAQH-SQRRESFLYRSDSDYELS-PKAMSRNSSVASD-LHGEDMIVTPFAQ---------VLASLRTVRSNVAALAHLQGRGAAKQASVENP------LFGSQPP----PPTEDTGQKLALETLDELDWCLDQLETLQTRHSVGEMASNKFKRMLNRELTHLSETSRSGNQVSEYISQTFLDQQTEMELPRVTPM-ETPR-------------------PMSQISG-----LRGLPHSASLS-AATIPRFGVQTDQEGQLAKELEDTNKWG-LDVFKVAELSGNRPLTTIIFSIFQERDLLKTFQIPADTLATYLLMLESHYHADVAYHNSLHAADVAQSTHVLLATPALEAVFTDLEVLAAVFASAIHDVDHPGVSNQFLINTNSELALMYNDASVLENHHLAVGFKLLQAENCDIFQNLSAKQRQSLRRMVIDMVL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175280"/>
                <a:tab algn="l" pos="83502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ourier New"/>
              </a:rPr>
              <a:t>Ecab_PDE4C  FDLENGLSS--GRSPLDPQAGPSLG-RIVQVAAQH-SQRRESFLYRSDSDFQLL-PKATSWNSSVASD-LQGEDMIVTPFAQ---------VLASLRTVRSNVAALAHLQGRGATKQAPVGKP------PSGSQAP----PSTEDPGQKLALETLDELDWCLDQLETLQTRHSVGEMASNKFKRMLNRELTHLSETSRSGNQVSEYISRTFLDQQTEVELPRVTPT-EPPK-------------------PISQISG-----LRGLPHSASLS-AATFPRFGVQTDQEGQLAKELEDTNKWG-LDVFKVAELSGNRPLTAIIFSIFQERDLLKTFQIPADTLVTYLLTLEGHYRADVAYHNSLHAADVAQSTHVLLATPALQAVFTDLEVLAAIFASAIHDVDHPGVSNQFLINTNSELALMYNDASVLENHHLAVGFKLLQAENCDIFQNLSAKQRLSLRRMVIDMVL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175280"/>
                <a:tab algn="l" pos="83502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ourier New"/>
              </a:rPr>
              <a:t>Btau_PDE4C  FDLENGLSC--GRSILDPRAGSGFG-QIVQAPAQH-SQRRESFLYRSDSDYELS-SKTMSRNSSVASD-LHGEDLIVTPFAQ---------VLASLRTVRSNVAALARLQDRGAAKQACVCNT------PSGSQPP----PPK-DTGQKLALETLDELDWCLDQLETLQTRHSVGEMASNKFKRMLNRELTHLSETSRSGNQVSEYISQTFLEQQTEVELPRATPA-EPPR-------------------PVSQISS-----LRGLPHSSSLS-TATVPRFGVQTDQEGQLAKELEDTSKWG-LDVFKVAELSGNRPLTAIMFSIFQERDLLKTFQIPADTLATYLLMLEGHYHNDVAYHNSLHAADVAQSTHVLLATPALEAVFTDLEVLAAIFASAIHDVDHPGVSNQFLINTNSELALMYNDASVLENHHLAVGFKLLQAENCDIFQNLSTKQRLSLRKMVIDIVL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175280"/>
                <a:tab algn="l" pos="83502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ourier New"/>
              </a:rPr>
              <a:t>Mdom_PDE4C  FDLENGLSS--GRSPLDPQTSPGSG-LVIQGNFPH-SQRRESFLYRSDSDYDLS-PKAMSRNSSTASD-LHGEDMIVTPFDPGGGWCLPSQVLASLRTVRSNFAVLTRLQDRV---------------AKPTSDLKV---PPTEDACQKLAMETLEELDWCLDQLETLQTRHSVSEMASNKFKRMLNRELTHLSETSRSGNQVSEYISRTFLGELRTREQVDGGSETDLRKKTKTLG-------------KGQLISG-----VRKLTHGSSFS-AAAIPRFGVKTDHETLLAKELKDTNKWG-LDVFKVAELSGNRPLTAIMYSIFQERDLLKTFRIPVDTLVTYLLTLEDHYHADVAYHNSIHAADVAQSTHVLLSTPALEAVFTDLEILAAIFASAIHDVDHPGVSNQFLINTNSELALMYNDASVLENHHLAVGFKLLQEDNCDIFQNLRPKQRQSLRKMVIDMVL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175280"/>
                <a:tab algn="l" pos="83502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ourier New"/>
              </a:rPr>
              <a:t>Xtro_PDE4C  --------------------------LVLQGNFPH-SQRRESFLYRSDSDYDLS-PKAMSRNSSIASD-LHGEDMIVTPFAQ---------VLASLRTVRSNFAMLTHLQDRVSNKRSSGSNQ------PSACKP-----NLSEDAVQKLAIETLEELDWCLDQLETLQTRHSVSEMASNKFKRMLNRELTHLSETSRSGNQVSEYISSTFLDKQHEVEIPTPVS-KEKDKKKR----------------PMSQISG-----VKKLTHSSSFS-NCSIPRFGVKTEQEVPLAKEVENINKWG-LDIFKVAEYSGNRPLTVIMYSIFQERDLLKTFHIPVDTFITYMMTLEDHYHSDVAYHNNIHAADVAQSTHVLLSTPALEAVFTDLEIMAAIFASAIHDVDHPGVSNQFLINTNSELALMYNDASVLENHHLAVGFKLLQEENCDIFQNLTKKQRQTLRKMVIDMVL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175280"/>
                <a:tab algn="l" pos="83502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ourier New"/>
              </a:rPr>
              <a:t>Olat_PDE4C1 FDVENGLSV--GRSPLDSQTSPGSG-LVLQGNFPH-SQRRESFLYRSDSDFDLS-PKAMSRNSSTASD-LHGEDMIVTPFAQ---------VLASLRTVRSNFAVLKKKNNLHLCSRWPPGST-----QPPICKPCL---AE--EPYQKLAMETLEELDWCLDQLETLQTRHSVSDMASNKFKRMLNRELTQLSETSRSGNQVSEFIANTFLEKQHDVEILSPPL-KEKEKKKR----------------PMSQISG-----VKKATQSPSLP-PASISRFGVNTPHESLLAKEIEDIDRWG-MDIFKIAEYSGNRPLTVIMYSIFQERDLLKTFKIQADTFITFMMTLEDHYHADVAYHNNIHAADVVQSTHVLLSTPALEAVFTDLEIMAALFASAIHDVDHPGVTNQFLINTSSELALMYNDASVLENHHLAVGFKLLQEENCDIFENLSKKQKDSLRKMVIDMVL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175280"/>
                <a:tab algn="l" pos="83502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ourier New"/>
              </a:rPr>
              <a:t>Trub_PDE4C1 FDVENGLSV--GRSPLDPQASPGSG-LVIQANFPH-SQRRESFLYRSDSDFDLS-PKGPSRNSSTASD-LHTEDMIVTPFAQ---------VLASLRTVRGNFAIITNQQDRPVSKTRSAGSN-----PPSMCKTSL---A--EEPHQQLAIETLDELDWCLEQLETLKTRHSVSEMASNKFKRMLNRELSQLSETSRSGNQVSEFISSTFLEKQHDMDIMSTPT-KEKDKKKR----------------PMSQISG-----VKKATHSPSLA-PSTIPRFGVNASQEGLLAKEMEDVNRWG-IDIFKIAEYSGRRPLTVTMYTIFQERELLKSFKIPTDTFLTFMMTLEDHYHADVAYHNNIHAADVVQSTHVLLSTPALEAVFTDLEILAALFASAIHDVDHPGVSNQFLINTNSELALMYNDSSVLENHHLAVGFKLLQEDNCDIFQNLSKKQRQSLRKMVIDMVL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175280"/>
                <a:tab algn="l" pos="83502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ourier New"/>
              </a:rPr>
              <a:t>Trub_PDE4C2 FDVENGLSV--GRSPLDSQTSPGSG-LVLQANFPH-SQRRESFLYRSDSDFDLS-PKTMSRNSSTASD-LHGEDMIVTPFAQ---------VLASLRTVRGNFVALTHLQDRVGNKRQ-TGSN-----QPPVCKPCV---T--EEPCPKLALETLEELDWCLDQLETLQTRHSVSEMASNKFKRMLNRELTQLSETSRSGNQVSEFIANTFLEKQHDVEILSPPP-KEREKKKR----------------PMSQISG-----VKKVIP--SLA-SVSIPRFGVNTPQESQLAKELEEINRWG-LDMFKISEFSGNRPLTVIMYSVFQERDLLKTFKIPVGTFVTFVMTLEDHYHGDVAYHNNIHAADVVQSTHVLLSTPALEAVFTDLEIMAALFASAIHDVDHPGVTNQFLINTSSELALMYNDASVLENHHLAVGFKLLQEENCDIFQNLSKKQKDSLRKMVIDMVL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175280"/>
                <a:tab algn="l" pos="83502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ourier New"/>
              </a:rPr>
              <a:t>Drer_PDE4C1 FDVENGLSV--GRSPLDSQASPGSG-LVLQANFPH-SQRRESFLYRSDSDFDLS-PKAMSRNSSTASE-LHGEDMIVTPFAQ---------VLASLRTVRSNFAVLTHQQDRVPSKK-STGNN-----PPSMCKTSL---P--EEPFQKLAVETLDELDWCLEQLETLKTRHSVSEMASNKFKRMLNRELTQLSETSKSGNQVSEYISSTFLEKQHDMDIMSTPS-KEKEKKKR----------------PMSQISG-----VKKPTHSSNIA-PSSIPRFGVSTNREDLLAKELEDFDRWG-VDMFKISECSGNRPLTVAMYTTFQERDLLKSFKIPVDTFINYMTALEENYRSDVAYHNSIHAADVVQSTHVLLSTPALEAVFTDLEILAAMFASAIHDVDHPGVSNQFLINTNSELALMYNDSSVLENHHLAVGFKLLQEENCDIFQNLTKKQRQSLRKMVIDMVL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175280"/>
                <a:tab algn="l" pos="83502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ourier New"/>
              </a:rPr>
              <a:t>Drer_PDE4C2 FDVENGLSM--GRSSLDPSPSS--G-LVLQANS----QRRESFLYRSDSDFDLS-PKTMSRNSSTASE-LHGEDMIVTPFAQ---------VLASLRTVRGNVAALTHMQDRSNKRPS--GTN-----PQSACKTNL---S--DEAYQKLTVETLEELDWCLDQLETLQTRHSVSEMASNKFKRMLNRELTQLSETSRSGNQVSEFIASTILQKQYDVELLSAAC-KE-EKKRR----------------PMSQISG-----VRKLSPSPSLP-PTCIPRFGVNTQHESLLAKELEDLDRWG-IDIFKIAEYSGNRPLTVMMYTIFQERDLLKTFKIPSDTFLTFLMTLEDHYHADVAYHNNIHAADVVQSTHVLLSTPALEDVFTDLEIMAALFASAIHDVDHPGVTNQFLINTNSELALMYNDASVLENHHLAVGFKLLQEENCDIFCNLSKKQRQSLRQMTIDMVL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175280"/>
                <a:tab algn="l" pos="83502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ourier New"/>
              </a:rPr>
              <a:t>Gacu_PDE4C  FDVENGLAV--GRSPLDPQTSPGSGGLVLQANFPH-SQRRESFLYRSDSDFDLS-PKGPSRNSSAASD-LHTEDMIVTPFAQ---------VLASLRTVRSNFAVITDQQDRTASKTRSSGSN-----PPSMCKTSL---AGTEEPHQQLAIETLDELDWCLEQLETLKTRHSVSEMASNKFKRMLNRELTQLSETSRSGNQVSEFISSTFLEKQHDMDIMSPPT-KEKDKKKR----------------PMSQISG-----VKKATHSPSLA-PSTIPRFGVNASQEGLLAKELEEVNRWG-IDIFKVSEYSGNRPLTVTMYTIFQERDLLKSFKIPADTFITFMMTLEDHYHADVAYHNNIHAADVVQSTHVLLSTPALEAVFTDLEILAALFSSAIHDVDHPGVSNQFLINTNSELALMYNDSSVLENHHLAVGFKLLQEDNCDIFQNLGKKQRQSLRKIVIDMVL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175280"/>
                <a:tab algn="l" pos="83502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ourier New"/>
              </a:rPr>
              <a:t>Hsap_PDE4D  FDVDNGTSA--GRSPLDPMTSPGSG-LILQANFVH-SQRRESFLYRSDSDYDLS-PKSMSRNSSIASD-IHGDDLIVTPFAQ---------VLASLRTVRNNFAALTNLQ-DRAPSKRSPMCNQ-----PSINKA-----TITEEAYQKLASETLEELDWCLDQLETLQTRHSVSEMASNKFKRMLNRELTHLSEMSRSGNQVSEFISNTFLDKQHEVEIPSP-TQKEKEKKKR----------------PMSQISG-----VKKLMHSSSLT-NSSIPRFGVKTEQEDVLAKELEDVNKWG-LHVFRIAELSGNRPLTVIMHTIFQERDLLKTFKIPVDTLITYLMTLEDHYHADVAYHNNIHAADVVQSTHVLLSTPALEAVFTDLEILAAIFASAIHDVDHPGVSNQFLINTNSELALMYNDSSVLENHHLAVGFKLLQEENCDIFQNLTKKQRQSLRKMVIDIVL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175280"/>
                <a:tab algn="l" pos="83502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ourier New"/>
              </a:rPr>
              <a:t>Gacu_PDE4D  FDVDNGTSS--GRSPLDPMASPGSG-LILQANFVH-SQRRESFLYRSDSDYDLS-PKSMSRNSSIASD-IHGDDMIVTPFAQ---------VLASLRTVRNNFGALTNLQQDRASNKRSPMCNP-----PPITKT-----TFTEEAYQKLATETLEELDWCLDQLETLQTRHSVSEMASNKFKRMLNRELTHLSEMSRSGNQVSEFISSTFLDKQHEVEMPTPQTQKEKEKKNK----------------PMSQIIG-----VKKLQHSSSLT-NSNIPRFGVKSETEDELAKELEHVNKWG-RNVFKIAEFSGNRPLTVMMYTIFQERDLLKTFKIPLDTFITYLMTLEDHYHGDVAYHNNIHAADVTQSTHVLLSTPALEAVFTDLEILAAIFASAIHDVDHPGVSNQFLINTNSELALMYNDSSVLENHHLAVGFKLLQEENCDIFQNLNKKQRQSLRKMVIDIVL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175280"/>
                <a:tab algn="l" pos="83502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ourier New"/>
              </a:rPr>
              <a:t>Olat_PDE4D  FDVDNGTSS--GRSPLDPMASPGSG-LILQANFVH-SQRRESFLYRSDSDYDLS-PKSMSRNSSIASD-IHGDDMIVTPFAQ---------VLASLRTVRNNFGALTNVQQERASTKRSPMCNP-----PPITKT-----TFTEEAYQKLATETLEELDWCLDQLETLQTRHSVSEMASNKFKRMLNRELTHLSEMSRSGNQVSEFISSTFLDKQHEVEMPTPQTQKEKEKKNK----------------PMSQISG-----VKKLQHSSSLT-NSNIPRFGVKTETEDELAKELEHVNKWG-LNVFKITEFSGNRPLTVMMHTIFQERDLLKTFKIPLDTFITYLLTLEDHYHGDVAYHNNIHAADVTQSTHVLLSTPALEAVFTDLEILAAIFASAIHDVDHPGVSNQFLISTNSELALMYNDSSVLENHHLAVGFKLLQEENCDIFQNLTKKQRQSLRKMVIDIVL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175280"/>
                <a:tab algn="l" pos="83502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ourier New"/>
              </a:rPr>
              <a:t>Trub_PDE4D  FDVDNGTSS--GRSPLDPMASPGSG-LILQANFVH-SQRRESFLYRSDSDYDLS-PKSMSRNSSIASD-IHGDDMIVTPFAQ---------VLASLRTVRNNFGALTNLQQDRASNKRSPMCNP-----PPITKT-----TFTEEAYQKLATETLEELDWCLDQLETLQTRHSVSEMASNKFKRMLNRELTHLSEMSRSGNQVSEFISSTFLDKQHEVEMPCPQTQKEKEKKNK----------------PMSQISG-----VKKLQHSSSLT-NSNIPRFG-KTETEDELAKELEHVNKWG-LNVFKISEFSGNRPLTVMMYTIFQERDLLKTFKIPLDTFITYLMTLEDHYHGDVAYHNNIHAADVTQSTHVLLSTPALEAVFTDLEILAAIFASAIHDVDHPGVSNQFLINTNSELALMYNDSSVLENHHLAVGFKLLQDENCDIFQNLTKKQRQLLRKMVIDIVL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175280"/>
                <a:tab algn="l" pos="83502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ourier New"/>
              </a:rPr>
              <a:t>Acar_PDE4D  FDVDNGTSS--GRSPLDPMTSPGSG-LILQANFVH-SQRRESFLYRSDSDYDLS-PKSMSRNSSIASD-IHGDDLIVTPFAQ---------VLASLRTVRNNFAALTNLQ-DRAPSKRSPMCNQ-----PSINKA-----TITEEAYQKLASETLEELDWCLDQLETLQTRHSVSEMASNKFKRMLNRELTHLSEMSRSGNQVSEYISNTFLDKQHEVEIPSP-TQKEKEKKKR----------------PMSQISG-----VKKLMHSSSLT-NSSIPKFGVKTDQEDILAKELEDVNKWG-LQVFKIAEFSGNRPLTVIMYTIFQERELLKTFKIQPDMLITYLMTLEDHYHADVAYHNNIHAADVVQSTHVLLSTPALEAVFTDLEILAAIFASAIHDVDHPGVSNQFLINTNSELALMYNDSSVLENHHLAVGFKLLQEENCDIFQNLTKKQRQSLRKMVIDIVL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175280"/>
                <a:tab algn="l" pos="83502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ourier New"/>
              </a:rPr>
              <a:t>Cfam_PDE4D  FDVDNGTSA--GRSPLDPMTSPGSG-LILQANFVH-SQRRESFLYRSDSDYDLS-PKSMSRNSSIASD-IHGDDLIVTPFAQ---------VLASLRTVRNNFAALTNLQ-DRAPSKRSPMCNQ-----PSINKA-----TITEEAYQKLASETLEELDWCLDQLETLQTRHSVSEMASNKFKRMLNRELTHLSEMSRSGNQVSEYISNTFLDKQHEVEIPSP-TQKEKEKKKR----------------PMSQISG-----VKKLMHSSSLT-NSSIPRFGVKTEQEDVLAKELEDVNKWG-LHVFRIAELSGNRPLTVIMHTIFQERDLLKTFKIPVDTLITYLMTLEDHYHADVAYHNNIHAADVVQSTHVLLSTPALEAVFTDLEILAAIFASAIHDVDHPGVSNQFLINTNSELALMYNDSSVLENHHLAVGFKLLQEENCDIFQNLTKKQRQSLRKMVIDIVL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175280"/>
                <a:tab algn="l" pos="83502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ourier New"/>
              </a:rPr>
              <a:t>Btau_PDE4D  FDVDNGTSS--GRSPLDPMTSPGSG-LILQANFVH-SQRRESFLYRSDSDYDLS-PKSMSRNSSIASD-IHGDDLIVTPFAQ---------VLASLRTVRNNFAALTNLQ-DRAPSKRSPMCNQ-----PSINKA-----TLTEEAYQKLASETLEELDWCLDQLETLQTRHSVSEMASNKFKRMLNRELTHLSEMSRSGNQVSEYISNTFLDKQHEVEIPSP-TQKEKEKKKR----------------PMSQISG-----VKKLMHSSSLT-NSSIPRFGVKTEQEDVLAKELEDVNKWG-LHVFRIAELSGNRPLTVIMHTIFQERDLLKTFKIPVDTLITYLMTLEDHYHADVAYHNNIHAADVVQSTHVLLSTPALEAVFTDLEILAAIFASAIHDVDHPGVSNQFLINTNSELALMYNDSSVLENHHLAVGFKLLQEENCDIFQNLTKKQRQSLRKMVIDIVL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175280"/>
                <a:tab algn="l" pos="83502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ourier New"/>
              </a:rPr>
              <a:t>Mdom_PDE4D  FDVDNGTSS--GRSPLDPMTSPGSG-LILQANFVH-SQRRESFLYRSDSDYDLS-PKSMSRNSSIASD-IHGDDLIVTPFAQ---------VLASLRTVRNNFAALTNLQ-DRAPNKRSPMCNQ-----PSINKA-----TITEEAYQKLASETLEELDWCLDQLETLQTRHSVSEMASNKFKRMLNRELTHLSEMSRSGNQVSEFISSTFLDKQHEVEIPSP-TQKEKEKKKR----------------PMSQISG-----VKKLMHSSSLT-NSSIPRFGVKTDQEDGLAKELEDVNKWG-LHVFKIAEFSGNRPLTVIMHTIFQERDLLKTFKIPVDTLITYLMTLEDHYHADVAYHNNIHAADVVQSTHVLLSTPALEAVFTDLEILAAIFASAIHDVDHPGVSNQFLINTNSELALMYNDSSVLENHHLAVGFKLLQEENCDIFQNLTKKQRQSLRKMVIDIVL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175280"/>
                <a:tab algn="l" pos="83502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ourier New"/>
              </a:rPr>
              <a:t>Ecab_PDE4D  FDVDNGTSS--GRSPLDPMTSPGSG-LILQANFVH-SQRRESFLYRSDSDYDLS-PKSMSRNSSIASD-IHGDDLIVTPFAQ---------VLASLRTVRNNFAALTNLQ-DRAPSKRSPMCNQ-----PSINKA-----TITEEAYQKLASETLEELDWCLDQLETLQTRHSVSEMASNKFKRMLNRELTHLSEMSRSGNQVSEYISNTFLDKQHEVEIPSP-TQKEKEKKKR----------------PMSQISG-----VKKLMHSSSLT-NSSIPRFGVKTEQEDVLAKELEDVNKWG-LHVFRIAELSGNRPLTVIMHTIFQERDLLKTFKIPVDTLITYLMTLEDHYHADVAYHNNIHAADVVQSTHVLLSTPALEAVFTDLEILAAIFASAIHDVDHPGVSNQFLINTNSELALMYNDSSVLENHHLAVGFKLLQEENCDIFQNLTKKQRQSLRKMVIDIVL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175280"/>
                <a:tab algn="l" pos="83502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ourier New"/>
              </a:rPr>
              <a:t>Rnor_PDE4D  FDVDNGTSA--GRSPLDPMTSPGSG-LILQANFVH-SQRRESFLYRSDSDYDLS-PKSMSRNSSIASD-IHGDDLIVTPFAQ---------VLASLRTVRNNFAALTNLQ-DRAPSKRSPMCNQ-----PSINKA-----TITEEAYQKLASETLEELDWCLDQLETLQTRHSVSEMASNKFKRMLNRELTHLSEMSRSGNQVSEYISNTFLDKQHEVEIPSP-TQKEKEKKKR----------------PMPQISG-----VKKLMHSSSLT-NSCIPRFGVKTEQEDVLAKELEDVNKWG-LHVFRIAELSGNRPLTVIMHTIFQERDLLKTFKIPVDTLITYLMTLEDHYHADVAYHNNIHAADVVQSTHVLLSTPALEAVFTDLEILAAIFASAIHDVDHPGVSNQFLINTNSELALMYNDSSVLENHHLAVGFKLLQEENCDIFQNLTKKQRQSLRKMAIDIVL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175280"/>
                <a:tab algn="l" pos="83502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ourier New"/>
              </a:rPr>
              <a:t>Mmus_PDE4D  FDVDNGTSA--GRSPLDPMTSPGSG-LILQANFVH-SQRRESFLYRSDSDYDLS-PKSMSRNSSIASD-IHGDDLIVTPFAQ---------VLASLRTVRNNFAALTNLQ-DRAPSKRSPMCNQ-----PSINKA-----TITEEAYQKLASETLEELDWCLDQLETLQTRHSVSEMASNKFKRMLNRELTHLSEMSRSGNQVSEYISNTFLDKQHEVEIPSP-TQKEKEKKKR----------------PMSQISG-----VKKLMHSSSLT-NSCIPRFGVKTEQEDVLAKELEDVNKWG-LHVFRIAELSGNRPLTVIMHTIFQERDLLKTFKIPVDTLITYLMTLEDHYHADVAYHNNIHAADVVQSTHVLLSTPALEAVFTDLEILAAIFASAIHDVDHPGVSNQFLINTNSELALMYNDSSVLENHHLAVGFKLLQEENCDIFQNLTKKQRQSLRKMVIDIVL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175280"/>
                <a:tab algn="l" pos="83502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ourier New"/>
              </a:rPr>
              <a:t>Cjac_PDE4D  FDVDNGTSA--GRSPLDPMTSPGSG-LILQANFVH-SQRRESFLYRSDSDYDLS-PKSMSRNSSIASD-IHGDDLIVTPFAQ---------VLASLRTVRNNFAALTNLQ-DRAPSKRSPMCNQ-----PSINKA-----TITEEAYQKLASETLEELDWCLDQLETLQTRHSVSEMASNKFKRMLNRELTHLSEMSRSGNQVSEYISNTFLDKQHEVEIPSP-TQKEKEKKKR----------------PMSQISG-----VKKLMHSSSLT-NSSIPRFGVKTEQEDVLAKELEDVNKWG-LHVFRIAELSGNRPLTVIMHTIFQERDLLKTFKIPVDTLITYLMTLEDHYHADVAYHNNIHAADVVQSTHVLLSTPALEAVFTDLEILAAIFASAIHDVDHPGVSNQFLINTNSELALMYNDSSVLENHHLAVGFKLLQEENCDIFQNLTKKQRQSLRKMVIDIVL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175280"/>
                <a:tab algn="l" pos="83502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ourier New"/>
              </a:rPr>
              <a:t>Drer_PDE4D  FDVDNGTSS--GRSPLDPMASPGSG-LILQANFVH-SQRRESFLYRSDSDYDLS-PKSMSRNSSIASD-IHGDDMIVTPFAQ---------VLASLRTVRNNFAALTNVQQERSNNKRSPMCNP-----PPITKT-----SYTEEAYQKLATETLEELDWCLDQLETLQTRHSVSEMASNKFKRMLNRELTHLSEMSRSGNQVSEYISSTFLDKQNEVEMPSPQSQKDKEKKKR----------------PMSQISG-----VKKLTHSSSLT-NSNIPRFGVKTETEDELAKELEDVNKWG-LNVFKVSEFSGNRPLTVMMYTIFQERDLLKTFKIPLDTFITYLMTLEDHYHADVAYHNNIHAADVTQSTHVLLSTPALEAVFTDLEILAAIFASAIHDVDHPGVSNQFLINTNSELALMYNDSSVLENHHLAVGFKLLQEENCDIFQNLTKKQRQSLRKMVIDIVL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175280"/>
                <a:tab algn="l" pos="83502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175280"/>
                <a:tab algn="l" pos="83502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175280"/>
                <a:tab algn="l" pos="83502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175280"/>
                <a:tab algn="l" pos="83502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175280"/>
                <a:tab algn="l" pos="83502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175280"/>
                <a:tab algn="l" pos="83502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175280"/>
                <a:tab algn="l" pos="83502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175280"/>
                <a:tab algn="l" pos="83502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175280"/>
                <a:tab algn="l" pos="83502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175280"/>
                <a:tab algn="l" pos="83502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ourier New"/>
              </a:rPr>
              <a:t>Cint_PDE4   TDMSKHMQLLANLKTMVETKKVAASGVLMLDNYTDR---------IQVLQNMVHCADLSNSSKPIEAYKQWVARLIDEFWMQGDVEREAGLEISPLCDRHNTSIERSQVMFIDFVVHPLLETWADLVNPYAQDIINQLASNRE-YYASRLPNLPSPNETS------------------------DCDVTVVDDSSTETEGDESDDDVIQTPVPTSQLQNNRFQFQISLDEDSSVSELSERRKSREMTNKPPR--------------------------------------------------------------------------------------------------------------------------------------------------------------------------------------------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175280"/>
                <a:tab algn="l" pos="83502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ourier New"/>
              </a:rPr>
              <a:t>Hsap_PDE4A  TDMSKHMTLLADLKTMVETKKVTSSGVLLLDNYSDR---------IQVLRNMVHCADLSNPTKPLELYRQWTDRIMAEFFQQGDRERERGMEISPMCDKHTASVEKSQVGFIDYIVHPLWETWADLVHPDAQEILDTLEDNRDW-YYSAIRQSPSPPPEEE--------------SRGPGHPPLPDKFQFELTLEEEEEEEISMAQIPCTAQEALTAQGLSGVEEALDATIAWEASPAQESLEVMAQEASLEAELEAVYLTQQAQSTGSAPVAPDEFSSREEFVVAVSHSSPSALALQSPLLPAWRTLSVSEHAPGLPGLPSTAAEVEAQREHQAAKRACSACAGTFGEDTSALPAPGGGGSGGDPT*------------------------------------------------------------------------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175280"/>
                <a:tab algn="l" pos="83502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ourier New"/>
              </a:rPr>
              <a:t>Cjac_PDE4A  TDMSKHMTLLADLKTMVETKKVTSSGVLLLDNYSDR---------IQVLRNMVHCADLSNPTKPLELYRQWTDRIMAEFFQQGDRERERGMEISPMCDKHTASVEKSQVGFIDYIVHPLWETWADLVHPDAQEILDTLEDNRDW-YYSAIRQSPSPPPEGE--------------SRGPGHPPPPDKFQFELTLEEEEEEETSVAQEALTSQGLSAAEGALDATMDPSPAQESLEVMAQDTPLEAELEEVDLTQLAESTGSAPVAQDEFSSQEESVVAVSCGSPSALSLQSPLLPAWRTLSVSEDAPGLPGLPSTAAEVEAQREHQAAKRACSACAETSGEETSAFPAPGWWGSDGDPT*--------------------------------------------------------------------------------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175280"/>
                <a:tab algn="l" pos="83502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ourier New"/>
              </a:rPr>
              <a:t>Mmus_PDE4A  TDMSKHMTLLADLKTMVETKKVTSSGVLLLDNYSDR---------IQVLRNMVHCADLSNPTKPLELYRQWTDRIMAEFFQQGDRERERGMEISPMCDKHTASVEKSQVGFIDYIVHPLWETWADLVHPDAQDILDTLEDNRDW-YHSAIRQSPSPTLEEE--------------PGVLSDPALPDKFQFELTLEEEDEEDSLEVPGLPCTEETLLAPHDTRAQAMEQSKVKGQSPAVVEVAESLKQETASAHGAPEESAEAVGHSFSLETSILPDLRTLSPSEEAQGLLGLPSMAAEVEAPRDHLAAMRACSACSGTSGDNSAVISAPGRWGSGGDPA*----------------------------------------------------------------------------------------------------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175280"/>
                <a:tab algn="l" pos="83502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ourier New"/>
              </a:rPr>
              <a:t>Rnor_PDE4A  TDMSKHMTLLADLKTMVETKKVTSSGVLLLDNYSDR---------IQVLRNMVHCADLSNPTKPLELYRQWTDRIMAEFFQQGDRERERGMEISPMCDKHTASVEKSQVGFIDYIVHPLWETWADLVHPDAQDILDTLEDNRDW-YHSAIRQSPSPPLEEE--------------PGGLGHPSLPDKFQFELTLEEEEEEDSLEVPGLPTTEETFLAAEDARAQAVDWSKVKGPSTTVVEVAERLKQETASAYGAPQESMEAVGCSFSPGTPILPDVRTLSSSEEAPGLLGLPSTAAEVEAPRDHLAATRACSACSGTSGDNSAIISAPGRWGSGGDPA*----------------------------------------------------------------------------------------------------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175280"/>
                <a:tab algn="l" pos="83502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ourier New"/>
              </a:rPr>
              <a:t>Cfam_PDE4A  TDMSKHMTLLADLKTMVETKKVTSSGVLLLDNYSDR---------IQVLRNMVHCADLSNPTKPLELYRQWTDRIMAEFFQQGDRERERGMEISPMCDKHTASVEKSQVQFYSPIVHPLWETWADLVHPDAQEILDTLEDNRDW-YYSAIRQSPSPPPEEE--------------PRRPGHPPPPDKFQFELTLEEEEEEEVSTAPGAFEVQGLSMAQDPSPAEDLLEA-------------------------------------------------------------------------------------------------------------------------------------------------------------------------------------------------------------------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175280"/>
                <a:tab algn="l" pos="83502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ourier New"/>
              </a:rPr>
              <a:t>Btau_PDE4A  TDMSKHMTLLADLKTMVETKKVTSSGVLLLDNYSDR---------IQVLRNMVHCADLSNPTKPLELYRQWTDRIMAEFFQRGDRERERGMEISPMCDKHTASVEKSQVGFIDYIVHPLWETWADLVHPDAQEILDTLEDNRDW-YYSAIRQSPSPPPEEE--------------PGGPGHPPPPDKFQFELTLDEEEEEEVCTAPGAVAIQELYMAQDASPPEDPLEVDGQDPYAEVEIEEMYLTRQVDSTGSVAAGQDVSVPQGASVDVCVGCRNIPALSPNSLAPLALRTPPPPEDDPGLLGLPSMAAEVGAQKEHQAAKRACCACTGTAGEDPTPGALPAPGAWGSAGGPT*------------------------------------------------------------------------------------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175280"/>
                <a:tab algn="l" pos="83502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ourier New"/>
              </a:rPr>
              <a:t>Sscr_PDE4A  TDMSKHMTLLADLKTMVETKKVTSSGVLLLDNYSDR---------IQVLRNMVHCADLSNPTKPLELYRQWTDRIMAEFFQQGDRERERGMEISPMCDKHTASVEKSQVGFIDYIVHPLWETWADLVHPDAQEILDTLEDNRDW-YYSAIRQSPSPPPEEE--------------PGGPGHPPLPDKFQFELTLEEEEEEEVSTGPGAVKVQELSTAPDAEQPLEVEEMYLTQRADLADSVATGGQDGPTSPDASLDAVGCSSPPALSSESFPLPALRTLPPPEGDPGLLGLPSMAAEVGAQKEHQAAKRACCACTGTSAEDPPTLSAPGGWGPAGGPT*----------------------------------------------------------------------------------------------------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175280"/>
                <a:tab algn="l" pos="83502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ourier New"/>
              </a:rPr>
              <a:t>Mdom_PDE4A  TDMSKHMSLLADLKTMVETKKVTSSGVLLLDNYTDR---------IQVLRNMVHCADLSNPTKPLALYRQWTDRIMEEFFRQGDKERERGMEISPMCDKHTASVEKSQVGFIDYIVHPLWETWADLVHPDAQEILDMLEDNRDW-YHRAIPQSPSPPPEEP--------------PG-----LSQDKFQFELIHEEDATTTKTATLLEEKDEPAPEVGRVGPGHGPEEGSLPAPISTRPLSPSRAGAIYQSCGSPDGMEQEKQQTQEPLAPEEVQILLASPSEETEASEAVAEAKAEAPSLAEEEIAEEAQPWTPPSPPTTSTFFQQQQQQQQHLWRQWRRQWRHRQQQEQEQQQQQQQQPQQQQKLATRTAGLALLPQTRSFLSPTPTPIPFCLSPSPRPNPASHPKRPAVSCFFPRPSWRLLPPSPSALVLAPSSPP*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175280"/>
                <a:tab algn="l" pos="83502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ourier New"/>
              </a:rPr>
              <a:t>Acar_PDE4A  TDMSKHMSLLADLKTMVETKKVTSSGVLLLDNYTDR---------IQVLRNMVHCADLSNPTKPLELYRQWTDRIMEEFFRQGDKERERGMEISPMCDKHTASVEKSQVGFIDYIVHPLWETWADLVHPDAQDILDTLEDNRDW-YHSMIPQSPSPPPDD----------------AEKDDEACLEKFQFELTLEEEGEDSEQSDKDCSSPGDEDNSYYTAAEEHPHESLEGQDRLTDDTSPGAS*L*GRDNGKGGKNKTTYIHTATHREKV------------------------------------------------------------------------------------------------------------------------------------------------------------------------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175280"/>
                <a:tab algn="l" pos="83502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ourier New"/>
              </a:rPr>
              <a:t>Xlae_PDE4A  TDMSKHMSLLADLKTMVETKKVTSSGVLLLDNYTDR---------IQVLRNMVHCADLSNPTKPLELYRQWTDRILEEFFRQGDKERERGMEISPMCDKHTASVEKSQVGFIDYIVHPLWETWSDLVHPDAQDILDTLEDNRDW-YQGMIPQSPSPPPDD----------------PDKDEEACIEKFQFELTLEEEAEDSDKDRNSGIEEEDGHCLHEATEIQELEEEFMAMHEGQTEQTDVYSDNSSPVEDS*-----------------------------------------------------------------------------------------------------------------------------------------------------------------------------------------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175280"/>
                <a:tab algn="l" pos="83502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ourier New"/>
              </a:rPr>
              <a:t>Gacu_PDE4A1 TDMSKHMSLLADLKTMVETKKVTSSGVLLLDHYTDR---------IQVLRNMVHCADLSNPTKPLAVYRQWTERIMEEFFRQGDKERERGMEISPMCDKHTASVEKSQVGFIDYIVHPLWETWGDLVHPDAQDILDTLEDNRDW-YQSTIPQSPSPPPVC----------------QDKDLNACIDKFQFELTLEDSSPREEGDEGEHTANHVEQDCNGKKEEDVMGQLEVRYEKERLSDTSPVEEEEDSSSQAEDT*--------------------------------------------------------------------------------------------------------------------------------------------------------------------------------------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175280"/>
                <a:tab algn="l" pos="83502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ourier New"/>
              </a:rPr>
              <a:t>Gacu_PDE4A2 TDMSKHMTLLADLKTMVETKKVTSSGVLLLDHYTER---------IQVLRNMVHCADLSNPTKTLAIYRQWTERIMEEFFRQGDKERERGMEISAMCDKHTASVEKSQVGFIDYIVHPLWETWADLVHPDAQELLDTLEENREW--------YLSTMPQS--------------PSPPPDRHLQHDRFQFELTLED----------------------------------------------------------------------------------------------------------------------------------------------------------------------------------------------------------------------------------------------------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175280"/>
                <a:tab algn="l" pos="83502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ourier New"/>
              </a:rPr>
              <a:t>Trub_PDE4A1 TDMSKHMSLLADLKTMVETKKVTSSGVLLLDNYTDR---------IQVLRNMVHCADLSNPTKPLELYRQWTDRILEEFFRQGDKERERGMEISPMCDKHTASVEKSQVGFIDYIVHPLWETWADLVHPDAQDILDTLEDNRDW-YQGMIPQSPSPPPDD----------------PDKDEEACIEKFQFELTLEEEAEDSDKDRNSGIEEEDGNCLHEAPEIQEPEEEFMTMHEGQAEQTDVYSDNTSPVEDS*-----------------------------------------------------------------------------------------------------------------------------------------------------------------------------------------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175280"/>
                <a:tab algn="l" pos="83502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ourier New"/>
              </a:rPr>
              <a:t>Trub_PDE4A2 TDMSKHMTLLADLKTMVETKKVTSSGVLLLDHYTER---------IQVLRNMVHCADLSNPTKTLQLYRQWTERIMEEFFRQGDKERERGMEISAMCDKHTASVEKSQVGFIDYIVHPLWETWADLVHPDAQELLDTLEENRNW--------YLNIIPQS--------------PSPPPDRHLQHDRFQFELTLED----------------------------------------------------------------------------------------------------------------------------------------------------------------------------------------------------------------------------------------------------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175280"/>
                <a:tab algn="l" pos="83502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ourier New"/>
              </a:rPr>
              <a:t>Olat_PDE4A2 TDMSKHMTLLADLKTMVETKKVTSSGVLLLDHYTER---------IQLLKNMVHCADLSNPTKPLPLYRQWTERIMEEFFRQGDKERERGMEISAMCDKHTASVEKSQVGFIDYIVHPLWETWADLVHPDAQELLDTLEENREW--------YLTTMPQS--------------PSPPPDRHLQHDRFQFEITLED----------------------------------------------------------------------------------------------------------------------------------------------------------------------------------------------------------------------------------------------------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175280"/>
                <a:tab algn="l" pos="83502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ourier New"/>
              </a:rPr>
              <a:t>Drer_PDE4A  TDMSKHMSLLADLKTMVETKKVTSSGVLMLDHYNDR---------IQVLRNMVHCADLSNPTKPLAVYRQWTERIMEEFFQQGDKERERGMEISPMCDKHTASVEKSQVGFIDYIVHPLWETWGDLVHPDAQEILDTLEDNRDW-YQSTIPQSPSPPPDR----------------PDNELESCRNKFQFELTLEGETEDEAEEKMEDGEEVTEVMVERSGRRRLQVQSVVEEEDERQSDESPVEETEEEEKSSSPTDDT*-----------------------------------------------------------------------------------------------------------------------------------------------------------------------------------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175280"/>
                <a:tab algn="l" pos="83502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ourier New"/>
              </a:rPr>
              <a:t>Hsap_PDE4B  TDMSKHMSLLADLKTMVETKKVTSSGVLLLDNYTDR---------IQVLRNMVHCADLSNPTKSLELYRQWTDRIMEEFFQQGDKERERGMEISPMCDKHTASVEKSQVGFIDYIVHPLWETWADLVQPDAQDILDTLEDNRNW-YQSMIPQSPSPPLDE----------------QNRDCQGLMEKFQFELTLDEEDSEGPEKEGEGHSYFSSTKTLCVIDPENRDSLGETDIDIATEDKSPVDT*-------------------------------------------------------------------------------------------------------------------------------------------------------------------------------------------------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175280"/>
                <a:tab algn="l" pos="83502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ourier New"/>
              </a:rPr>
              <a:t>Cjac_PDE4B  TDMSKHMSLLADLKTMVETKKVTSSGVLLLDNYTDR---------IQVLRNMVHCADLSNPTKSLELYRQWTDRIMEEFFQQGDKERERGMEISPMCDKHTASVEKSQVGFIDYIVHPLWETWADLVQPDAQDILDTLEDNRNW-YQSMIPQSPSPPLDE----------------QNRDCQGLMEKFQFELTLDEEDSEGPEREGEGHSYFSSTKTLCVIDPENRDSLGETDIDIATEDTSPVDT*-------------------------------------------------------------------------------------------------------------------------------------------------------------------------------------------------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175280"/>
                <a:tab algn="l" pos="83502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ourier New"/>
              </a:rPr>
              <a:t>Mmus_PDE4B  TDMSKHMSLLADLKTMVETKKVTSSGVLLLDNYTDR---------IQVLRNMVHCADLSNPTKSLELYRQWTDRIMEEFFQQGDKERERGMEISPMCDKHTASVEKSQVGFIDYIVHPLWETWADLVQPDAQDILDTLEDNRNW-YQSMIPQSPSPPLDE----------------RSRDCQGLMEKFQFELTLEEEDSEGPEKEGEGHSYFSSTKTLCVIDPENRDSLEETDIDIATEDKSPIDT*-------------------------------------------------------------------------------------------------------------------------------------------------------------------------------------------------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175280"/>
                <a:tab algn="l" pos="83502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ourier New"/>
              </a:rPr>
              <a:t>Rnor_PDE4B  TDMSKHMSLLADLKTMVETKKVTSSGVLLLDNYTDR---------IQVLRNMVHCADLSNPTKSLELYRQWTDRIMEEFFQQGDKERERGMEISPMCDKHTASVEKSQVGFIDYIVHPLWETWADLVQPDAQDILDTLEDNRNW-YQSMIPQSPSPPLDE----------------RSRDCQGLMEKFQFELTLEEEDSEGPEKEGEGPNYFSSTKTLCVIDPENRDSLEETDIDIATEDKSLIDT*-------------------------------------------------------------------------------------------------------------------------------------------------------------------------------------------------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175280"/>
                <a:tab algn="l" pos="83502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ourier New"/>
              </a:rPr>
              <a:t>Cfam_PDE4B  TDMSKHMSLLADLKTMVETKKVTSSGVLLLDNYTDR---------IQVLRNMVHCADLSNPTKSLELYRQWTDRIMEEFFQQGDKERERGMEISPMCDKHTASVEKSQVGFIDYIVHPLWETWADLVQPDAQDILDTLEDNRNW-YQSMIPQSPSPPLDE----------------QNRDCQGLMEKFQFELTLEEEDSEGPDKEGEGHNYFSSTKTLCVIDPEHRDSLGDTDGDTGAENKTPIDT*-------------------------------------------------------------------------------------------------------------------------------------------------------------------------------------------------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175280"/>
                <a:tab algn="l" pos="83502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ourier New"/>
              </a:rPr>
              <a:t>Ecab_PDE4B  TDMSKHMSLLADLKTMVETKKVTSSGVLLLDNYTDR---------IQVLRNMVHCADLSNPTKSLELYRQWTDRIMEEFFQQGDKERERGMEISPMCDKHTASVEKSQVGFIDYIVHPLWETWADLVQPDAQDILDTLEDNRNW-YQSMIPQSPSPPLDE----------------QNRDCQGLMEKFQFELTLDEEDSEGPEKEGEGHSYFSSTKTLCVIDPESRDSLGETGVDMATEDKSPVDT*-------------------------------------------------------------------------------------------------------------------------------------------------------------------------------------------------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175280"/>
                <a:tab algn="l" pos="83502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ourier New"/>
              </a:rPr>
              <a:t>Btau_PDE4B  TDMSKHMSLLADLKTMVETKKVTSSGVLLLDNYTDR---------IQVLRNMVHCADLSNPTKSLELYRQWTDRIMEEFFQQGDKERERGMEISPMCDKHTASVEKSQVGFIDYIVHPLWETWADLVQPDAQDILDTLEDNRNW-YQSMIPQSPSPPLDE----------------QNRDCQGLMEKFQFELTLEEEDSEGPEKDGEGHSYFGSTKTLCVIDPENRDPLGETEVDITTEDKSPIDT*-------------------------------------------------------------------------------------------------------------------------------------------------------------------------------------------------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175280"/>
                <a:tab algn="l" pos="83502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ourier New"/>
              </a:rPr>
              <a:t>Sscr_PDE4B  TDMSKHMSLLADLKTMVETKKVTSSGVLLLDNYTDR---------IQVLRNMVHCADLSNPTKSLELYRQWTDRIMEEFFQQGDKERERGMEISPMCDKHTASVEKSQVGFIDYIVHPLWETWADLVQPDAQDILDTLEDNRNW-YQSMIPQSPSPPLDE----------------QNRDCQGLMEKFQFELTLEEEDSEGPEKEGEGHGYFGSTKTLCVIDPENRDSLGETGVDTATEDKSPTDT*-------------------------------------------------------------------------------------------------------------------------------------------------------------------------------------------------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175280"/>
                <a:tab algn="l" pos="83502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ourier New"/>
              </a:rPr>
              <a:t>Mdom_PDE4B  TDMSKHMGLLADLKTMVETKKVTSSGVLLLDNYTDR---------IQVLRNMVHCADLSNPTKSLELYRQWTDRIMEEFFQQGDKERERGMEISPMCDKHTASVEKSQVGFIDYIVHPLWETWADLVQPDAQDILDTLEDNRNW-YQSMIPQSPSPPLEE----------------QNPDCQGLMEKFQFELTLEEEDSEGPEKEGDSVSYLGSTKTLCVIDPEPCEADVETEMGDASPIDT*-----------------------------------------------------------------------------------------------------------------------------------------------------------------------------------------------------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175280"/>
                <a:tab algn="l" pos="83502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ourier New"/>
              </a:rPr>
              <a:t>Xlae_PDE4B  TDMSKHMSLLADLKTMVETKKVTSSGVLLLDNYTDR---------IQVLRNMVHCADLSNPTKSLELYRQWTDRIMEEFFQQGDRERERGMEISPMCDKHTASVEKSQVGFIDYIVHPLWETWGDLVQPDAQDILDTLEDNRNW-YQSMIPQSPSPLLDE----------------HDKDCQGLSEKFHFELTLEEEDSDGHDKDGDCLSFYSSTKTLHIVDQGMEDSPDADTELLTDDTSPLDT*--------------------------------------------------------------------------------------------------------------------------------------------------------------------------------------------------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175280"/>
                <a:tab algn="l" pos="83502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ourier New"/>
              </a:rPr>
              <a:t>Gacu_PDE4B2 TDMSKHMSLLADLKTMVETKKVTSSGVLLLDNYTDR---------IQVLRNMVHCADLSNPTKSLELYRQWTDRIMEEFFHQGDRERERGMEISPMCDKHTASVEKSQVGFIDYIVHPLWETWADLVHPDAQDILDTLEDNRNW-YQSMIPQSPSPPFFD---------QCTLGHGGGTGGQAGGEKFQFELTYSLGDSRSPPPDYSDGQELEEGRMMEPAIEIVTHEASPTDT*-------------------------------------------------------------------------------------------------------------------------------------------------------------------------------------------------------------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175280"/>
                <a:tab algn="l" pos="83502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ourier New"/>
              </a:rPr>
              <a:t>Gacu_PDE4B1 TDMSKHMSLLANLKTMVETKKVTSSGVLLLDNYTDR--------MQQVLRNMVHCADLSNPTKPLDLYRQWTDRIMEEFFHQGDRERDRGMEISPMCDKHTASVERTQVGFIDYIVHPLWETWADLVHPDAQDILDTLEDNRNW-YQRMIPQSPSPPFYT--------SDGESGQPGELEGGPVASKFQFELTLDDQDERDAGGENAVMETAGGVILEQHACDGDRVEMTTCDISPAET*--------------------------------------------------------------------------------------------------------------------------------------------------------------------------------------------------------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175280"/>
                <a:tab algn="l" pos="83502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ourier New"/>
              </a:rPr>
              <a:t>Olat_PDE4B1 TDMSKHMSLLANLKTMVETKKVTSSGVLLLDNYTDR---------MQVLRNMVHCADLSNPTKPLDLYRQWTDRIMDEFFHQGDRERERGMEISPMCDKNTASVERTQVGFIDYIVHPLWETWADLVHPDAQDILDTLEDNRNW-YQSMIPQSPSPPFYT--------SDGEGSQHEDSEGRSVDSRFQFDLSMDSQDSQAGHGHHETTDLAVTCDHVNKEDLSDLEDVDTTTRDVSPAET*------------------------------------------------------------------------------------------------------------------------------------------------------------------------------------------------------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175280"/>
                <a:tab algn="l" pos="83502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ourier New"/>
              </a:rPr>
              <a:t>Olat_PDE4B2 TDMSKHMSLLADLKTMVETKKVTSSGVLLLDNYTDR---------IQVLRNMVHCADLSNPTKPLELYRQWTDRIMDEFFHQGDRERERGMEISPMCDKHTASVEKSQVGFIDYIAHPLWETWADLVHPDAQDILDTLEDNRNW-YQSMIPQSPSPPFYD---------QGTHGHSGGTGGQGGGDKFQFDVTLEEEDLDGIDRDGEGEDDEVDSLADSPPPEYVDNQASEDNEMIEPMTAIEIVTHEASPTDT*-----------------------------------------------------------------------------------------------------------------------------------------------------------------------------------------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175280"/>
                <a:tab algn="l" pos="83502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ourier New"/>
              </a:rPr>
              <a:t>Trub_PDE4B1 TDMSKHMSLLADLKTMVETKKVTSSGVLLLDNYTDR---------MQVLRNMVHCADLSNPTKPLDLYRQWTDRIMDEFFHQGDRERERGMEISPMCDKHTASVERTQVGFIDYIVHPLWETWADLVHPDAQDILDTLEDNRNW-YQSMIPQSPSPPFYA--------SDDEGRRPEEVEGGPAPSKFQFELTLDDQDGHG-----------------------------------------------------------------------------------------------------------------------------------------------------------------------------------------------------------------------------------------------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175280"/>
                <a:tab algn="l" pos="83502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ourier New"/>
              </a:rPr>
              <a:t>Trub_PDE4B2 TDMSKHMSLLADLKTMVETKKVTSSGVLLLDNYTDR---------IQVLRNMVHCADLSNPTKSLELYRQWTDRIMDEFFHQGDRERERGMEISPMCDKHTASVEKSQVGFIDYIVHPLWETWADLVHPDAQDILDTLEDNRNW-YQSMIPQSPSPPFYE---------QSTHGHGGGTGGQGGGEKFQFELTLEEEELDGIEKECLGDSHSPPLDCLDVQEQEGSMMEPMTAIEIVTHEASPTDT*-------------------------------------------------------------------------------------------------------------------------------------------------------------------------------------------------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175280"/>
                <a:tab algn="l" pos="83502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ourier New"/>
              </a:rPr>
              <a:t>Drer_PDE4B  TDMSKHMSLLADLKTMVETKKVTSSGVLLLDNYTDR---------IQVLRNMVHCADLSNPTKSLELYRQWTDRIMEEFFHQGDRERERGMEISPMCDKHTASVEKSQVGFIDYIVHPLWETWADLVHPDAQDILDTLEDNRNW-YQSMIPQSPSPPFYQ-------------PDKEGNGGSSGPDKFQFELTLEEEDSEGTEKDEQSQGDEEEEAEEDRGEEMESTTHIQIVTEDASPVDT*-----------------------------------------------------------------------------------------------------------------------------------------------------------------------------------------------------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175280"/>
                <a:tab algn="l" pos="83502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ourier New"/>
              </a:rPr>
              <a:t>Hsap_PDE4C  TDMSKHMNLLADLKTMVETKKVTSLGVLLLDNYSDR---------IQVLQNLVHCADLSNPTKPLPLYRQWTDRIMAEFFQQGDRERESGLDISPMCDKHTASVEKSQVGFIDYIAHPLWETWADLVHPDAQDLLDTLEDNREW-YQSKIPRSPS--------------------DLTNPERDGPDRFQFELTLEEAEEEDEEEEEEGEETALAKEALELPDTELLSPEAGPDPGDLPLDNQRT*---------------------------------------------------------------------------------------------------------------------------------------------------------------------------------------------------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175280"/>
                <a:tab algn="l" pos="83502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ourier New"/>
              </a:rPr>
              <a:t>Cjac_PDE4C  TDMSKHMNLLADLKTMVETKKVTSLGVLLLDNYPDR---------IQVLQSLVHCADLSNPTKPLPLYRQWTDRIMAEFFQQGDRERESGLDISPMCDKHTASVEKSQVGFIDYIAHPLWETWADLVHPDAQDLLDTLEDNREW-YQSKIPRSPS--------------------SLTNPERGGPDKFQFGLPLEEAEEEEEEEEEEGEETALVKEALELSDTELPPKAVDSGDLPLDNQRT*-----------------------------------------------------------------------------------------------------------------------------------------------------------------------------------------------------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175280"/>
                <a:tab algn="l" pos="83502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ourier New"/>
              </a:rPr>
              <a:t>Mmus_PDE4C  TDMSKHMSLLADLKTMVETKKVTSLGVLLLDNYSDR---------IQ----------------------------------QGDRERESGLDISPMCDKHTASMEKSQVGFIDYIAQPLWETWADLVHPDAQELLDTLEDNREW------YQSRI--------------------PCSPPHTMGSDRFKFELTLEEAEEEEEEEDEGQCTALNRESSELPST*-------------------------------------------------------------------------------------------------------------------------------------------------------------------------------------------------------------------------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175280"/>
                <a:tab algn="l" pos="83502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ourier New"/>
              </a:rPr>
              <a:t>Rnor_PDE4C  TDMSKHMSLLADLKTMVETKKVTSLGVLLLDNYSDR---------IQVLQSLVHCADLSNPAKPLPLYRQWTERIMAEFFQQGDRERESGLDISPMCDKHTASVEKSQVGFIDYIAHPLWETWADLVHPDAQELLDTLEDNREW------YQSRV--------------------PCSPPHAIGPDRFKFELTLEETEEEEEEDERH*----------------------------------------------------------------------------------------------------------------------------------------------------------------------------------------------------------------------------------------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175280"/>
                <a:tab algn="l" pos="83502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ourier New"/>
              </a:rPr>
              <a:t>Cfam_PDE4C  TDMSKHMNLLADLKTMVETKKVTSLGVLLLDNYSDR---------IQVLQNLVHCADLSNPTKPLELYRRWTDRIMAEFFQQGDRERESGLDISPMCDKHTASVEKSQVGFIDYIAHPLWETWADLVHPDAQDLLDTLEDNREW-YQSKIPRSPV--------------------DLTSPQQDSPDRFHFELTLEEAEEEEEEEGALDTEVSESPDTELLAPEASLDRGAPLLDNQRTGGKPCVDHEANVMAEPFGT*--------------------------------------------------------------------------------------------------------------------------------------------------------------------------------------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175280"/>
                <a:tab algn="l" pos="83502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ourier New"/>
              </a:rPr>
              <a:t>Ecab_PDE4C  TDMSKHMSLLADLKTMVETKKVASLGVLLLDNYSDR---------IQVLQNLVHCADLSNPTKPLPLYRQWTDRIMAEFFQQGDRERESGLDVSPMCDKHTASVEKSQVGFIDYIAHPLWETWADLVHPDAQDLLDTLEDNREW-YQSKVPRSPM--------------------DPTSPEQGSPDRFQFELTLDEAEEEKEAEEEGALDGEASESPDTELLSPEASLDPGGLLLDNQRT--------------------------------------------------------------------------------------------------------------------------------------------------------------------------------------------------------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175280"/>
                <a:tab algn="l" pos="83502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ourier New"/>
              </a:rPr>
              <a:t>Btau_PDE4C  TDMSKHMNLLADLKTMVETKKVTSLGVLLLDNYSDR---------IQVLQSLVHCADLSNPTKPLPLYRQWTDRIMAEFFQQGDSERESGLDISPMCDKHTASVEKSQVGFIDYIAHPLWETWADLVHPDAQDLLDTLEDNREW-YQSKIPRSPE--------------------DPTSPKQGSPDRFQFQLPLEEAEEEEEEEEEALDGEASKSPDTELLSSEASPDPGAPHLDYQRTVGKPCTDHEGNAVAEPLGT*-------------------------------------------------------------------------------------------------------------------------------------------------------------------------------------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175280"/>
                <a:tab algn="l" pos="83502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ourier New"/>
              </a:rPr>
              <a:t>Mdom_PDE4C  TDMSKHMNLLADLKTMVETKKVTSLGVLLLDNYSDR---------IQVLQNMVHCADLSNPTKPLELYRQWTDRIMVEFFQQGDREREKGIEISPMCDKHTASVEKSQVGFIDYIAHPLWETWADLVHPDAQEILDTLEDNREW-YQSMIPRSPDGGHEA----------------GPAKGGGAADKFQFELTLEEEEGESDSEAEEPGSRAEEGEEENSGSDSKTLATDDSESAE------------------------------------------------------------------------------------------------------------------------------------------------------------------------------------------------------------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175280"/>
                <a:tab algn="l" pos="83502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ourier New"/>
              </a:rPr>
              <a:t>Xtro_PDE4C  TDMSKHMNLLADLKTMVETKKVTSLGVLLLDNYSDR---------IQVLQNMVHCADLSNPTKPLEIYRQWTDRIIVEFFHQGDREREKGMEISPMCDKHNASVEKSQVGFIDYIVHPLWETWADLVHPDAQEILDTLEDNREW-YQSMIPQSPSPPPEE---------------QDPDRGNAAGDKFQFELTLEEEGESDTEQEDTESPIDEENSDSKIHATDDSAQASDEAEQSSPVDLCMTVSSKLDHLEIPPKSTLTKQKKILNFDNLKLAGERTIQQKEVSSSHATPANSARQEGTGQAEICLDQEGNITYLPLGT*----------------------------------------------------------------------------------------------------------------------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175280"/>
                <a:tab algn="l" pos="83502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ourier New"/>
              </a:rPr>
              <a:t>Olat_PDE4C1 TDMSKHINFLADMKTMVETKKVTNLGVLLLDNYSDRIQAKFGMLFLQVLQNMVHCADLSNPTKPLELYRKWTDRIMVELFTQGDREREKGMEISPMCDKQNASIEKTQVGFIDYVVHPLWETWADLVHPDAQEILDTLEDNREW-YQSMIPRSPSPTSPEEHHNEGRPSDGAVGTGGLAHLGGGGDKFQFELTLEEEEEEVDSDLESPIEEESQTSRDRHLDSSSP----------------------------------------------------------------------------------------------------------------------------------------------------------------------------------------------------------------------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175280"/>
                <a:tab algn="l" pos="83502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ourier New"/>
              </a:rPr>
              <a:t>Trub_PDE4C1 TDMSKHMNLLADLKTMVETKKVTSLGVLLLDNYSDR---------IQVLQNMVHCADLSNPTKPLELYRQWTDRIMVEFFTQGDRERDKGMEISPMCDKQNASIEKNQVGFIDYIVHPLWETWADLVHPDAQEILDTLEDNREW-YQSMIPRSPSPGPEQ-----QEVGGHAGEASALSRGSGSTDKFQFKLTLEEEEDKEAEQEDAPGVSRF-----------------------------------------------------------------------------------------------------------------------------------------------------------------------------------------------------------------------------------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175280"/>
                <a:tab algn="l" pos="83502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ourier New"/>
              </a:rPr>
              <a:t>Trub_PDE4C2 TDMSKHMNYLADMKTMVETKKVTSLGVLLLDNYSD---------RIQVLQNIVHCADLSNPTKPLELYRRWTDRIMREFFTQGDRERDKGMEISPMCDKHNASIEKSQVGFIDYIVHPLWETWADLVHPDAQEILDTLEDNREW-YQSMIPRSPSPSSPE--------------HDAKGSGGGGGDKFQFELTLEEEEEDEVESELESQKE-------------------------------------------------------------------------------------------------------------------------------------------------------------------------------------------------------------------------------------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175280"/>
                <a:tab algn="l" pos="83502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ourier New"/>
              </a:rPr>
              <a:t>Drer_PDE4C1 TDMSKHMNLLADLKTMVETKKVTSLGVLLLDNYSDR---------IQVLQNMVHCADLSNPTKPLELYRQWTDRIMVEFFTQGDRERDKGMEISPMCDKHNASIEKSQVGFIDYIVHPLWETWADLVHPDAQEILDTLEDNREW-YQSMIPHSPTSTPED-------KSAVMGMGAMGGGIASAGDKFQFELTLEEEGESDVESPVDEDLTSS-----------------------------------------------------------------------------------------------------------------------------------------------------------------------------------------------------------------------------------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175280"/>
                <a:tab algn="l" pos="83502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ourier New"/>
              </a:rPr>
              <a:t>Drer_PDE4C2 TDMSKHMNFLADLKTMVETKKVTSQGVLLLDNYSDR------IQVLQATFNMVHCADLSNPTKPLELYRKWTDRIMVEFFSQGDRERDKGIDVSPMCDKHTASMENTQVGFIDYIIHPLWETWADLVHPDAQDILDTLEDNREW-YQSMIPRSPSPTPEE------------QDSRPTGVTGSAGEKFQFELTLEEEDGELETEEEHTDIERSRTMTDPEHPQTSPLGITTILDSSERELDQELTSVSALQLETSSSSTHE*----------------------------------------------------------------------------------------------------------------------------------------------------------------------------------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175280"/>
                <a:tab algn="l" pos="83502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ourier New"/>
              </a:rPr>
              <a:t>Gacu_PDE4C  TDMSKHMNLLADLKTMVETKKVTSLGVLLLDNYSDR---------IQVLQNMVHCADLSNPTKPLELYRRWTDRIMVEFFTQGDRERDKGMEISPMCDKQNASIEKNQVGFIDYIVHPLWETWADLVHPDAQEILDTLEDNREW-YQSMIPHSPSPHPED---QQEGARAGESSALIGGGGSVSADKFQFELTLEEERESDTESPPEEEEGFSSSRGTELSRTDSGSRTFSLDSDMAEDREADQE---------------------------------------------------------------------------------------------------------------------------------------------------------------------------------------------------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175280"/>
                <a:tab algn="l" pos="83502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ourier New"/>
              </a:rPr>
              <a:t>Hsap_PDE4D  TDMSKHMNLLADLKTMVETKKVTSSGVLLLDNYSDR---------IQVLQNMVHCADLSNPTKPLQLYRQWTDRIMEEFFRQGDRERERGMEISPMCDKHNASVEKSQVGFIDYIVHPLWETWADLVHPDAQDILDTLEDNREW-YQSTIPQSPSPAPDD----------------PEEGRQGQTEKFQFELTLEEDGESDTEKDSGSQVEED----------TSCSDSKTLCTQDSESTEIPLDEQVEEEAVGEEEESQPEACVIDDRSPDT*----------------------------------------------------------------------------------------------------------------------------------------------------------------------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175280"/>
                <a:tab algn="l" pos="83502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ourier New"/>
              </a:rPr>
              <a:t>Gacu_PDE4D  TDMSKHMNLLADLKTMVETKKVTSSGVLLLDNYSDR---------IQVLQNMVHCADLSNPTKPLQLYRQWTDRIMDEFFSQGDRERERGMEISPMCDKHNASVEKSQVGFIDYIVHPLWETWADLVHPDAQDILDTLEDNREW-YQSTIPQSPSPALDD---------------PEDGSRPPGGDKFQFELTLEEDGESDTEKDSGSQPEE----------EEDCTDSKTLCTQDSESTEIPLDEQVGEDEGEEEEEVTE-----------------------------------------------------------------------------------------------------------------------------------------------------------------------------------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175280"/>
                <a:tab algn="l" pos="83502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ourier New"/>
              </a:rPr>
              <a:t>Olat_PDE4D  TDMSKHMNLLADLKTMVETKKVTSSGVLLLDNYSDR---------IQVLQNMVHCADLSNPTKPLQLYRQWTDRIMEEFFSQGDRERERGMEISPMCDKHNASVEKSQVGFIDYIAHPLWETWADLVHPDAQDILDTLEDNREW-YQSTIPQSPSPALDE---------------PEDGSRPPGGDKFQFELTLEEDGESDTEKDSGSQPEE----------ENSCTDSKTLCTQDSESTEIPLDEQVGEDEDDEEEEHE------------------------------------------------------------------------------------------------------------------------------------------------------------------------------------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175280"/>
                <a:tab algn="l" pos="83502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ourier New"/>
              </a:rPr>
              <a:t>Trub_PDE4D  TDMSKHMNLLADLKTMVETQKVTSSGVLLLDNYSDR---------IQVLQNMVHCADLSNPTKPLQLYRQWTDRIMEEFFSQGDRERERGMEISPMCDKHNASVEKNQVGFIDYIVHPLWETWADLVHPDAQVILDTLEDNREF-YQSTIPQSPSPTLDE---------------PEDGTRPPGGDKFQFELTLEEDGESDTEKDSGSQPEEDEEEEEEDEEENSCTDSKTLCTQDSESTEIPLDEQVGLATPPVSFVQT------------------------------------------------------------------------------------------------------------------------------------------------------------------------------------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175280"/>
                <a:tab algn="l" pos="83502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ourier New"/>
              </a:rPr>
              <a:t>Acar_PDE4D  TDMSKHMNLLADLKTMVETKKVTSSGVLLLDNYSDR---------IQVLQNMVHCADLSNPTKPLQLYRQWTDRIMEEFFRQGDRERERGMEISPMCDKHNASVEKSQVGFIDYIVHPLWETWADLVHPDAQDILDTLEDNREW-YQSTIPQSPSPAPDD----------------QEEGRQGQTDKFQFELTLEEDGESDTEKDSGSQVEED----------TSCSDSKTLCTQDSESTEIPLDEQVGGEVEEEEEEEQSQTEHCVQEEHSPDT*--------------------------------------------------------------------------------------------------------------------------------------------------------------------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175280"/>
                <a:tab algn="l" pos="83502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ourier New"/>
              </a:rPr>
              <a:t>Cfam_PDE4D  TDMSKHMNLLADLKTMVETKKVTSSGVLLLDNYSDR---------IQVLQNMVHCADLSNPTKPLQLYRQWTDRIMEEFFRQGDRERERGMEISPMCDKHNASVEKSQVGFIDYIVHPLWETWADLVHPDAQDILDTLEDNREW-YQSTIPQSPSPAPDE----------------QEEGRQGQTEKFQFELTLEEDGESDTEKDSGSQVEED----------TSCSDSKTLCTQDSESTEIPLDEQVEEETVGEEENSQPEACVIEDHSPDT*----------------------------------------------------------------------------------------------------------------------------------------------------------------------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175280"/>
                <a:tab algn="l" pos="83502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ourier New"/>
              </a:rPr>
              <a:t>Btau_PDE4D  TDMSKHMNLLADLKTMVETKKVTSSGVLLLDNYSDR---------IQVLQNMVHCADLSNPTKPLQLYRQWTDRIMEEFFRQGDRERERGMEISPMCDKHNASVEKSQVGFIDYIVHPLWETWADLVHPDAQDILDTLEDNREW-YQSTIPQSPSPAPDD----------------QEEGRQGQTEKFQFELTLEEDGESDTEKDSGSQVEED----------TSCSDSKTLCTQDSESTEIPLDEQVEEEAVADEE-SQPEACVIGDPSPDT*----------------------------------------------------------------------------------------------------------------------------------------------------------------------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175280"/>
                <a:tab algn="l" pos="83502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ourier New"/>
              </a:rPr>
              <a:t>Mdom_PDE4D  TDMSKHMNLLADLKTMVETKKVTSSGVLLLDNYSDR---------IQVLQNMVHCADLSNPTKPLQLYRQWTDRIMEEFFRQGDRERERGMEISPMCDKHNASVEKSQVGFIDYIVHPLWETWADLVHPDAQDILDTLEDNREW-YQSTIPQSPSPAPDD----------------QEEGRQGQTEKFQFELTLEEDGESDTEKDSGSPVEED----------TSCSDSKTLCTQDSESTEIPLDEQVEEEAVGEEEEEEDPAEPCAIENEHSPDT*-------------------------------------------------------------------------------------------------------------------------------------------------------------------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175280"/>
                <a:tab algn="l" pos="83502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ourier New"/>
              </a:rPr>
              <a:t>Ecab_PDE4D  TDMSKHMNLLADLKTMVETKKVTSSGVLLLDNYSDR---------IQVLQNMVHCADLSNPTKPLQLYRQWTDRIMEEFFRQGDRERERGMEISPMCDKHNASVEKSQVGFIDYIVHPLWETWADLVHPDAQDILDTLEDNREW-YQSTIPQSPSPAPDD----------------QEEGRQGQTEKFQFELTLEEDGESDTEKDSGSQVEED----------TSCSDSKTLCTQDSESTEIPLDEQVEEEAVGEEEESQPEACAAEDRSPDT*----------------------------------------------------------------------------------------------------------------------------------------------------------------------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175280"/>
                <a:tab algn="l" pos="83502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ourier New"/>
              </a:rPr>
              <a:t>Rnor_PDE4D  TDMSKHMNLLADLKTMVETKKVTSSGVLLLDNYSDR---------IQVLQNMVHCADLSNPTKPLQLYRQWTDRIMEEFFRQGDRERERGMEISPMCDKHNASVEKSQVGFIDYIVHPLWETWADLVHPDAQDILDTLEDNREW-YQSTIPQSPSPAPDD----------------QEDGRQGQTEKFQFELTLEEDGESDTEKDSGSQVEED----------TSCSDSKTLCTQDSESTEIPLDEQVEEEAVAEEE-SQPQTGVADDCCPDT*----------------------------------------------------------------------------------------------------------------------------------------------------------------------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175280"/>
                <a:tab algn="l" pos="83502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ourier New"/>
              </a:rPr>
              <a:t>Mmus_PDE4D  TDMSKHMNLLADLKTMVETKKVTSSGVLLLDNYSDR---------IQVLQNMVHCADLSNPTKPLQLYRQWTDRIMEEFFRQGDRERERGMEISPMCDKHNASVEKSQVGFIDYIVHPLWETWADLVHPDAQDILDTLEDNREW-YQSTIPQSPSPAPDD----------------QEEGRQGQTEKFQFELTLEEDCESDTEKDSGSQVEED----------TSCSDSKTLCTQDSESTEIPLDEQVEEEAVAEEE-SQPETCVPDDCCPDT*----------------------------------------------------------------------------------------------------------------------------------------------------------------------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175280"/>
                <a:tab algn="l" pos="83502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ourier New"/>
              </a:rPr>
              <a:t>Cjac_PDE4D  TDMSKHMNLLADLKTMVETKKVTSSGVLLLDNYSDR---------IQVLQNMVHCADLSNPTKPLQLYRQWTDRIMEEFFRQGDRERERGMEISPMCDKHNASVEKSQVGFIDYIVHPLWETWADLVHPDAQDILDTLEDNREW-YQSTIPQSPSPAPDD----------------PEEGRQGQTEKFQFELTLEEDGESDTEKDSGSQVEED----------TSCSDSKTLCTQDSESTEIPLDEQVEEEAVGEEEESQPEACVIDDRSPDT*----------------------------------------------------------------------------------------------------------------------------------------------------------------------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175280"/>
                <a:tab algn="l" pos="83502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ourier New"/>
              </a:rPr>
              <a:t>Drer_PDE4D  TDMSKHMNLLADLKTMVETKKVTSSGVLLLDNYSDR---------IQVLQNMVHCADLSNPTKPLQLYRQWTDRIMEEFFSQGDRERERGMEISPMCDKHNASVEKSQVGFIDYIVHPLWETWADLVHPDAQDILDTLEDNREW-YQSTIPQSPSPALDT---------------SSEGRRAAGQEKFQFELTLEEDGESDTEKDSGSPPEEDEEEEEE--EENSCSDSKTLCTQDSECTEIPLDEQVGDVPHEDEYEHEENREISEPCVLEEEEEEEEEEEEDTANT*-------------------------------------------------------------------------------------------------------------------------------------------------------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4175280"/>
                <a:tab algn="l" pos="83502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"/>
          <p:cNvSpPr/>
          <p:nvPr/>
        </p:nvSpPr>
        <p:spPr>
          <a:xfrm>
            <a:off x="5105520" y="2332080"/>
            <a:ext cx="380880" cy="1130616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"/>
          <p:cNvSpPr/>
          <p:nvPr/>
        </p:nvSpPr>
        <p:spPr>
          <a:xfrm>
            <a:off x="18840600" y="15285960"/>
            <a:ext cx="266400" cy="1130616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"/>
          <p:cNvSpPr/>
          <p:nvPr/>
        </p:nvSpPr>
        <p:spPr>
          <a:xfrm>
            <a:off x="15602040" y="15314760"/>
            <a:ext cx="380880" cy="1130616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"/>
          <p:cNvSpPr/>
          <p:nvPr/>
        </p:nvSpPr>
        <p:spPr>
          <a:xfrm>
            <a:off x="1619280" y="2057400"/>
            <a:ext cx="432529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"/>
          <p:cNvSpPr/>
          <p:nvPr/>
        </p:nvSpPr>
        <p:spPr>
          <a:xfrm>
            <a:off x="5305320" y="2114640"/>
            <a:ext cx="3049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001"/>
              </a:spcBef>
              <a:tabLst>
                <a:tab algn="l" pos="0"/>
                <a:tab algn="l" pos="4175280"/>
                <a:tab algn="l" pos="83502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*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"/>
          <p:cNvSpPr/>
          <p:nvPr/>
        </p:nvSpPr>
        <p:spPr>
          <a:xfrm>
            <a:off x="12204720" y="1689120"/>
            <a:ext cx="0" cy="6094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"/>
          <p:cNvSpPr/>
          <p:nvPr/>
        </p:nvSpPr>
        <p:spPr>
          <a:xfrm>
            <a:off x="14798520" y="1684440"/>
            <a:ext cx="0" cy="6094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"/>
          <p:cNvSpPr/>
          <p:nvPr/>
        </p:nvSpPr>
        <p:spPr>
          <a:xfrm>
            <a:off x="21232800" y="1676520"/>
            <a:ext cx="0" cy="6094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"/>
          <p:cNvSpPr/>
          <p:nvPr/>
        </p:nvSpPr>
        <p:spPr>
          <a:xfrm>
            <a:off x="28598760" y="1684440"/>
            <a:ext cx="0" cy="6094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"/>
          <p:cNvSpPr/>
          <p:nvPr/>
        </p:nvSpPr>
        <p:spPr>
          <a:xfrm>
            <a:off x="15532200" y="15096960"/>
            <a:ext cx="2905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001"/>
              </a:spcBef>
              <a:tabLst>
                <a:tab algn="l" pos="0"/>
                <a:tab algn="l" pos="4175280"/>
                <a:tab algn="l" pos="83502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*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"/>
          <p:cNvSpPr/>
          <p:nvPr/>
        </p:nvSpPr>
        <p:spPr>
          <a:xfrm>
            <a:off x="11549160" y="14628960"/>
            <a:ext cx="0" cy="6094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"/>
          <p:cNvSpPr/>
          <p:nvPr/>
        </p:nvSpPr>
        <p:spPr>
          <a:xfrm flipV="1">
            <a:off x="1625760" y="14968440"/>
            <a:ext cx="40480920" cy="28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8000" bIns="-18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"/>
          <p:cNvSpPr/>
          <p:nvPr/>
        </p:nvSpPr>
        <p:spPr>
          <a:xfrm>
            <a:off x="3067200" y="15295680"/>
            <a:ext cx="1314360" cy="1130616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"/>
          <p:cNvSpPr/>
          <p:nvPr/>
        </p:nvSpPr>
        <p:spPr>
          <a:xfrm>
            <a:off x="15712920" y="15096960"/>
            <a:ext cx="2905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001"/>
              </a:spcBef>
              <a:tabLst>
                <a:tab algn="l" pos="0"/>
                <a:tab algn="l" pos="4175280"/>
                <a:tab algn="l" pos="83502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*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"/>
          <p:cNvSpPr/>
          <p:nvPr/>
        </p:nvSpPr>
        <p:spPr>
          <a:xfrm>
            <a:off x="2171880" y="1486080"/>
            <a:ext cx="897228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1250"/>
              </a:spcBef>
              <a:tabLst>
                <a:tab algn="l" pos="0"/>
                <a:tab algn="l" pos="4175280"/>
                <a:tab algn="l" pos="83502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"/>
              </a:rPr>
              <a:t>CRFL-UCR1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"/>
          <p:cNvSpPr/>
          <p:nvPr/>
        </p:nvSpPr>
        <p:spPr>
          <a:xfrm>
            <a:off x="8991720" y="1486080"/>
            <a:ext cx="897228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1250"/>
              </a:spcBef>
              <a:tabLst>
                <a:tab algn="l" pos="0"/>
                <a:tab algn="l" pos="4175280"/>
                <a:tab algn="l" pos="83502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"/>
              </a:rPr>
              <a:t>LR1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"/>
          <p:cNvSpPr/>
          <p:nvPr/>
        </p:nvSpPr>
        <p:spPr>
          <a:xfrm>
            <a:off x="13354200" y="1486080"/>
            <a:ext cx="897228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1250"/>
              </a:spcBef>
              <a:tabLst>
                <a:tab algn="l" pos="0"/>
                <a:tab algn="l" pos="4175280"/>
                <a:tab algn="l" pos="83502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"/>
              </a:rPr>
              <a:t>UCR2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"/>
          <p:cNvSpPr/>
          <p:nvPr/>
        </p:nvSpPr>
        <p:spPr>
          <a:xfrm>
            <a:off x="20345400" y="1486080"/>
            <a:ext cx="897264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1250"/>
              </a:spcBef>
              <a:tabLst>
                <a:tab algn="l" pos="0"/>
                <a:tab algn="l" pos="4175280"/>
                <a:tab algn="l" pos="83502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"/>
              </a:rPr>
              <a:t>LR2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"/>
          <p:cNvSpPr/>
          <p:nvPr/>
        </p:nvSpPr>
        <p:spPr>
          <a:xfrm>
            <a:off x="27374760" y="1486080"/>
            <a:ext cx="897264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1250"/>
              </a:spcBef>
              <a:tabLst>
                <a:tab algn="l" pos="0"/>
                <a:tab algn="l" pos="4175280"/>
                <a:tab algn="l" pos="83502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"/>
              </a:rPr>
              <a:t>Catalytic Domain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"/>
          <p:cNvSpPr/>
          <p:nvPr/>
        </p:nvSpPr>
        <p:spPr>
          <a:xfrm>
            <a:off x="2419200" y="14439960"/>
            <a:ext cx="897264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1250"/>
              </a:spcBef>
              <a:tabLst>
                <a:tab algn="l" pos="0"/>
                <a:tab algn="l" pos="4175280"/>
                <a:tab algn="l" pos="83502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"/>
              </a:rPr>
              <a:t>Catalytic Domain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"/>
          <p:cNvSpPr/>
          <p:nvPr/>
        </p:nvSpPr>
        <p:spPr>
          <a:xfrm>
            <a:off x="19507320" y="14420880"/>
            <a:ext cx="897228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1250"/>
              </a:spcBef>
              <a:tabLst>
                <a:tab algn="l" pos="0"/>
                <a:tab algn="l" pos="4175280"/>
                <a:tab algn="l" pos="83502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"/>
              </a:rPr>
              <a:t>Carboxy-Termini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"/>
          <p:cNvSpPr/>
          <p:nvPr/>
        </p:nvSpPr>
        <p:spPr>
          <a:xfrm>
            <a:off x="17716680" y="2044800"/>
            <a:ext cx="2030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1001"/>
              </a:spcBef>
              <a:tabLst>
                <a:tab algn="l" pos="0"/>
                <a:tab algn="l" pos="4175280"/>
                <a:tab algn="l" pos="83502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#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"/>
          <p:cNvSpPr/>
          <p:nvPr/>
        </p:nvSpPr>
        <p:spPr>
          <a:xfrm>
            <a:off x="23050440" y="2502000"/>
            <a:ext cx="1473120" cy="125712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"/>
          <p:cNvSpPr/>
          <p:nvPr/>
        </p:nvSpPr>
        <p:spPr>
          <a:xfrm>
            <a:off x="1476360" y="13677840"/>
            <a:ext cx="3618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751"/>
              </a:spcBef>
              <a:tabLst>
                <a:tab algn="l" pos="0"/>
                <a:tab algn="l" pos="4175280"/>
                <a:tab algn="l" pos="83502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"/>
          <p:cNvSpPr/>
          <p:nvPr/>
        </p:nvSpPr>
        <p:spPr>
          <a:xfrm>
            <a:off x="3505320" y="13677840"/>
            <a:ext cx="3618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751"/>
              </a:spcBef>
              <a:tabLst>
                <a:tab algn="l" pos="0"/>
                <a:tab algn="l" pos="4175280"/>
                <a:tab algn="l" pos="83502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2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"/>
          <p:cNvSpPr/>
          <p:nvPr/>
        </p:nvSpPr>
        <p:spPr>
          <a:xfrm>
            <a:off x="5353200" y="13677840"/>
            <a:ext cx="3618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751"/>
              </a:spcBef>
              <a:tabLst>
                <a:tab algn="l" pos="0"/>
                <a:tab algn="l" pos="4175280"/>
                <a:tab algn="l" pos="83502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4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"/>
          <p:cNvSpPr/>
          <p:nvPr/>
        </p:nvSpPr>
        <p:spPr>
          <a:xfrm>
            <a:off x="7191360" y="13677840"/>
            <a:ext cx="3618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751"/>
              </a:spcBef>
              <a:tabLst>
                <a:tab algn="l" pos="0"/>
                <a:tab algn="l" pos="4175280"/>
                <a:tab algn="l" pos="83502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6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"/>
          <p:cNvSpPr/>
          <p:nvPr/>
        </p:nvSpPr>
        <p:spPr>
          <a:xfrm>
            <a:off x="9029880" y="13677840"/>
            <a:ext cx="3618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751"/>
              </a:spcBef>
              <a:tabLst>
                <a:tab algn="l" pos="0"/>
                <a:tab algn="l" pos="4175280"/>
                <a:tab algn="l" pos="83502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8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"/>
          <p:cNvSpPr/>
          <p:nvPr/>
        </p:nvSpPr>
        <p:spPr>
          <a:xfrm>
            <a:off x="10829880" y="13677840"/>
            <a:ext cx="4478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751"/>
              </a:spcBef>
              <a:tabLst>
                <a:tab algn="l" pos="0"/>
                <a:tab algn="l" pos="4175280"/>
                <a:tab algn="l" pos="83502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"/>
          <p:cNvSpPr/>
          <p:nvPr/>
        </p:nvSpPr>
        <p:spPr>
          <a:xfrm>
            <a:off x="12668400" y="13677840"/>
            <a:ext cx="4474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751"/>
              </a:spcBef>
              <a:tabLst>
                <a:tab algn="l" pos="0"/>
                <a:tab algn="l" pos="4175280"/>
                <a:tab algn="l" pos="83502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12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"/>
          <p:cNvSpPr/>
          <p:nvPr/>
        </p:nvSpPr>
        <p:spPr>
          <a:xfrm>
            <a:off x="14506560" y="13677840"/>
            <a:ext cx="4478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751"/>
              </a:spcBef>
              <a:tabLst>
                <a:tab algn="l" pos="0"/>
                <a:tab algn="l" pos="4175280"/>
                <a:tab algn="l" pos="83502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14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"/>
          <p:cNvSpPr/>
          <p:nvPr/>
        </p:nvSpPr>
        <p:spPr>
          <a:xfrm>
            <a:off x="16354440" y="13668480"/>
            <a:ext cx="4478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751"/>
              </a:spcBef>
              <a:tabLst>
                <a:tab algn="l" pos="0"/>
                <a:tab algn="l" pos="4175280"/>
                <a:tab algn="l" pos="83502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16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"/>
          <p:cNvSpPr/>
          <p:nvPr/>
        </p:nvSpPr>
        <p:spPr>
          <a:xfrm>
            <a:off x="18183240" y="13668480"/>
            <a:ext cx="4478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751"/>
              </a:spcBef>
              <a:tabLst>
                <a:tab algn="l" pos="0"/>
                <a:tab algn="l" pos="4175280"/>
                <a:tab algn="l" pos="83502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18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"/>
          <p:cNvSpPr/>
          <p:nvPr/>
        </p:nvSpPr>
        <p:spPr>
          <a:xfrm>
            <a:off x="19945440" y="13668480"/>
            <a:ext cx="4474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751"/>
              </a:spcBef>
              <a:tabLst>
                <a:tab algn="l" pos="0"/>
                <a:tab algn="l" pos="4175280"/>
                <a:tab algn="l" pos="83502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2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"/>
          <p:cNvSpPr/>
          <p:nvPr/>
        </p:nvSpPr>
        <p:spPr>
          <a:xfrm>
            <a:off x="21783600" y="13668480"/>
            <a:ext cx="4478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751"/>
              </a:spcBef>
              <a:tabLst>
                <a:tab algn="l" pos="0"/>
                <a:tab algn="l" pos="4175280"/>
                <a:tab algn="l" pos="83502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22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"/>
          <p:cNvSpPr/>
          <p:nvPr/>
        </p:nvSpPr>
        <p:spPr>
          <a:xfrm>
            <a:off x="23717160" y="13668480"/>
            <a:ext cx="4478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751"/>
              </a:spcBef>
              <a:tabLst>
                <a:tab algn="l" pos="0"/>
                <a:tab algn="l" pos="4175280"/>
                <a:tab algn="l" pos="83502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24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"/>
          <p:cNvSpPr/>
          <p:nvPr/>
        </p:nvSpPr>
        <p:spPr>
          <a:xfrm>
            <a:off x="25555680" y="13668480"/>
            <a:ext cx="4474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751"/>
              </a:spcBef>
              <a:tabLst>
                <a:tab algn="l" pos="0"/>
                <a:tab algn="l" pos="4175280"/>
                <a:tab algn="l" pos="83502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26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"/>
          <p:cNvSpPr/>
          <p:nvPr/>
        </p:nvSpPr>
        <p:spPr>
          <a:xfrm>
            <a:off x="27403560" y="13668480"/>
            <a:ext cx="4474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751"/>
              </a:spcBef>
              <a:tabLst>
                <a:tab algn="l" pos="0"/>
                <a:tab algn="l" pos="4175280"/>
                <a:tab algn="l" pos="83502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28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"/>
          <p:cNvSpPr/>
          <p:nvPr/>
        </p:nvSpPr>
        <p:spPr>
          <a:xfrm>
            <a:off x="29241720" y="13668480"/>
            <a:ext cx="4478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751"/>
              </a:spcBef>
              <a:tabLst>
                <a:tab algn="l" pos="0"/>
                <a:tab algn="l" pos="4175280"/>
                <a:tab algn="l" pos="83502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3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"/>
          <p:cNvSpPr/>
          <p:nvPr/>
        </p:nvSpPr>
        <p:spPr>
          <a:xfrm>
            <a:off x="31089600" y="13668480"/>
            <a:ext cx="4478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751"/>
              </a:spcBef>
              <a:tabLst>
                <a:tab algn="l" pos="0"/>
                <a:tab algn="l" pos="4175280"/>
                <a:tab algn="l" pos="83502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32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"/>
          <p:cNvSpPr/>
          <p:nvPr/>
        </p:nvSpPr>
        <p:spPr>
          <a:xfrm>
            <a:off x="32918400" y="13668480"/>
            <a:ext cx="4478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751"/>
              </a:spcBef>
              <a:tabLst>
                <a:tab algn="l" pos="0"/>
                <a:tab algn="l" pos="4175280"/>
                <a:tab algn="l" pos="83502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34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"/>
          <p:cNvSpPr/>
          <p:nvPr/>
        </p:nvSpPr>
        <p:spPr>
          <a:xfrm>
            <a:off x="34756560" y="13668480"/>
            <a:ext cx="4478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751"/>
              </a:spcBef>
              <a:tabLst>
                <a:tab algn="l" pos="0"/>
                <a:tab algn="l" pos="4175280"/>
                <a:tab algn="l" pos="83502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36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"/>
          <p:cNvSpPr/>
          <p:nvPr/>
        </p:nvSpPr>
        <p:spPr>
          <a:xfrm>
            <a:off x="36604440" y="13668480"/>
            <a:ext cx="4478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751"/>
              </a:spcBef>
              <a:tabLst>
                <a:tab algn="l" pos="0"/>
                <a:tab algn="l" pos="4175280"/>
                <a:tab algn="l" pos="83502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38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"/>
          <p:cNvSpPr/>
          <p:nvPr/>
        </p:nvSpPr>
        <p:spPr>
          <a:xfrm>
            <a:off x="38452320" y="13668480"/>
            <a:ext cx="4478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751"/>
              </a:spcBef>
              <a:tabLst>
                <a:tab algn="l" pos="0"/>
                <a:tab algn="l" pos="4175280"/>
                <a:tab algn="l" pos="83502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4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"/>
          <p:cNvSpPr/>
          <p:nvPr/>
        </p:nvSpPr>
        <p:spPr>
          <a:xfrm>
            <a:off x="40290840" y="13668480"/>
            <a:ext cx="4474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751"/>
              </a:spcBef>
              <a:tabLst>
                <a:tab algn="l" pos="0"/>
                <a:tab algn="l" pos="4175280"/>
                <a:tab algn="l" pos="83502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42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"/>
          <p:cNvSpPr/>
          <p:nvPr/>
        </p:nvSpPr>
        <p:spPr>
          <a:xfrm>
            <a:off x="42129000" y="13668480"/>
            <a:ext cx="4478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751"/>
              </a:spcBef>
              <a:tabLst>
                <a:tab algn="l" pos="0"/>
                <a:tab algn="l" pos="4175280"/>
                <a:tab algn="l" pos="83502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44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"/>
          <p:cNvSpPr/>
          <p:nvPr/>
        </p:nvSpPr>
        <p:spPr>
          <a:xfrm>
            <a:off x="43976880" y="13668480"/>
            <a:ext cx="4478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751"/>
              </a:spcBef>
              <a:tabLst>
                <a:tab algn="l" pos="0"/>
                <a:tab algn="l" pos="4175280"/>
                <a:tab algn="l" pos="83502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46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"/>
          <p:cNvSpPr/>
          <p:nvPr/>
        </p:nvSpPr>
        <p:spPr>
          <a:xfrm>
            <a:off x="2517840" y="26688960"/>
            <a:ext cx="4474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751"/>
              </a:spcBef>
              <a:tabLst>
                <a:tab algn="l" pos="0"/>
                <a:tab algn="l" pos="4175280"/>
                <a:tab algn="l" pos="83502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48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"/>
          <p:cNvSpPr/>
          <p:nvPr/>
        </p:nvSpPr>
        <p:spPr>
          <a:xfrm>
            <a:off x="4371840" y="26698680"/>
            <a:ext cx="4478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751"/>
              </a:spcBef>
              <a:tabLst>
                <a:tab algn="l" pos="0"/>
                <a:tab algn="l" pos="4175280"/>
                <a:tab algn="l" pos="83502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5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"/>
          <p:cNvSpPr/>
          <p:nvPr/>
        </p:nvSpPr>
        <p:spPr>
          <a:xfrm>
            <a:off x="6219720" y="26698680"/>
            <a:ext cx="4478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751"/>
              </a:spcBef>
              <a:tabLst>
                <a:tab algn="l" pos="0"/>
                <a:tab algn="l" pos="4175280"/>
                <a:tab algn="l" pos="83502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52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"/>
          <p:cNvSpPr/>
          <p:nvPr/>
        </p:nvSpPr>
        <p:spPr>
          <a:xfrm>
            <a:off x="8067600" y="26688960"/>
            <a:ext cx="4478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751"/>
              </a:spcBef>
              <a:tabLst>
                <a:tab algn="l" pos="0"/>
                <a:tab algn="l" pos="4175280"/>
                <a:tab algn="l" pos="83502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54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"/>
          <p:cNvSpPr/>
          <p:nvPr/>
        </p:nvSpPr>
        <p:spPr>
          <a:xfrm>
            <a:off x="9896400" y="26698680"/>
            <a:ext cx="4478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751"/>
              </a:spcBef>
              <a:tabLst>
                <a:tab algn="l" pos="0"/>
                <a:tab algn="l" pos="4175280"/>
                <a:tab algn="l" pos="83502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56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"/>
          <p:cNvSpPr/>
          <p:nvPr/>
        </p:nvSpPr>
        <p:spPr>
          <a:xfrm>
            <a:off x="11754000" y="26688960"/>
            <a:ext cx="4474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751"/>
              </a:spcBef>
              <a:tabLst>
                <a:tab algn="l" pos="0"/>
                <a:tab algn="l" pos="4175280"/>
                <a:tab algn="l" pos="83502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58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"/>
          <p:cNvSpPr/>
          <p:nvPr/>
        </p:nvSpPr>
        <p:spPr>
          <a:xfrm>
            <a:off x="13677840" y="26669880"/>
            <a:ext cx="4478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751"/>
              </a:spcBef>
              <a:tabLst>
                <a:tab algn="l" pos="0"/>
                <a:tab algn="l" pos="4175280"/>
                <a:tab algn="l" pos="83502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6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"/>
          <p:cNvSpPr/>
          <p:nvPr/>
        </p:nvSpPr>
        <p:spPr>
          <a:xfrm>
            <a:off x="15335280" y="26688960"/>
            <a:ext cx="4474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751"/>
              </a:spcBef>
              <a:tabLst>
                <a:tab algn="l" pos="0"/>
                <a:tab algn="l" pos="4175280"/>
                <a:tab algn="l" pos="83502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62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"/>
          <p:cNvSpPr/>
          <p:nvPr/>
        </p:nvSpPr>
        <p:spPr>
          <a:xfrm>
            <a:off x="16802280" y="26679600"/>
            <a:ext cx="4474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751"/>
              </a:spcBef>
              <a:tabLst>
                <a:tab algn="l" pos="0"/>
                <a:tab algn="l" pos="4175280"/>
                <a:tab algn="l" pos="83502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64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"/>
          <p:cNvSpPr/>
          <p:nvPr/>
        </p:nvSpPr>
        <p:spPr>
          <a:xfrm>
            <a:off x="18649800" y="26688960"/>
            <a:ext cx="4478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751"/>
              </a:spcBef>
              <a:tabLst>
                <a:tab algn="l" pos="0"/>
                <a:tab algn="l" pos="4175280"/>
                <a:tab algn="l" pos="83502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66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"/>
          <p:cNvSpPr/>
          <p:nvPr/>
        </p:nvSpPr>
        <p:spPr>
          <a:xfrm>
            <a:off x="20497680" y="26688960"/>
            <a:ext cx="4478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751"/>
              </a:spcBef>
              <a:tabLst>
                <a:tab algn="l" pos="0"/>
                <a:tab algn="l" pos="4175280"/>
                <a:tab algn="l" pos="83502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68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"/>
          <p:cNvSpPr/>
          <p:nvPr/>
        </p:nvSpPr>
        <p:spPr>
          <a:xfrm>
            <a:off x="22431240" y="26698680"/>
            <a:ext cx="4478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751"/>
              </a:spcBef>
              <a:tabLst>
                <a:tab algn="l" pos="0"/>
                <a:tab algn="l" pos="4175280"/>
                <a:tab algn="l" pos="83502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7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"/>
          <p:cNvSpPr/>
          <p:nvPr/>
        </p:nvSpPr>
        <p:spPr>
          <a:xfrm>
            <a:off x="24269760" y="26698680"/>
            <a:ext cx="4474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751"/>
              </a:spcBef>
              <a:tabLst>
                <a:tab algn="l" pos="0"/>
                <a:tab algn="l" pos="4175280"/>
                <a:tab algn="l" pos="83502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72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"/>
          <p:cNvSpPr/>
          <p:nvPr/>
        </p:nvSpPr>
        <p:spPr>
          <a:xfrm>
            <a:off x="26107920" y="26698680"/>
            <a:ext cx="4478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751"/>
              </a:spcBef>
              <a:tabLst>
                <a:tab algn="l" pos="0"/>
                <a:tab algn="l" pos="4175280"/>
                <a:tab algn="l" pos="83502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74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"/>
          <p:cNvSpPr/>
          <p:nvPr/>
        </p:nvSpPr>
        <p:spPr>
          <a:xfrm>
            <a:off x="27860760" y="26698680"/>
            <a:ext cx="4474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751"/>
              </a:spcBef>
              <a:tabLst>
                <a:tab algn="l" pos="0"/>
                <a:tab algn="l" pos="4175280"/>
                <a:tab algn="l" pos="83502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76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" name=""/>
          <p:cNvSpPr/>
          <p:nvPr/>
        </p:nvSpPr>
        <p:spPr>
          <a:xfrm>
            <a:off x="29689560" y="26688960"/>
            <a:ext cx="4474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751"/>
              </a:spcBef>
              <a:tabLst>
                <a:tab algn="l" pos="0"/>
                <a:tab algn="l" pos="4175280"/>
                <a:tab algn="l" pos="83502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78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"/>
          <p:cNvSpPr/>
          <p:nvPr/>
        </p:nvSpPr>
        <p:spPr>
          <a:xfrm>
            <a:off x="31546800" y="26679600"/>
            <a:ext cx="4478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751"/>
              </a:spcBef>
              <a:tabLst>
                <a:tab algn="l" pos="0"/>
                <a:tab algn="l" pos="4175280"/>
                <a:tab algn="l" pos="83502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8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"/>
          <p:cNvSpPr/>
          <p:nvPr/>
        </p:nvSpPr>
        <p:spPr>
          <a:xfrm>
            <a:off x="33384960" y="26688960"/>
            <a:ext cx="4478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751"/>
              </a:spcBef>
              <a:tabLst>
                <a:tab algn="l" pos="0"/>
                <a:tab algn="l" pos="4175280"/>
                <a:tab algn="l" pos="83502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82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"/>
          <p:cNvSpPr/>
          <p:nvPr/>
        </p:nvSpPr>
        <p:spPr>
          <a:xfrm>
            <a:off x="35223480" y="26688960"/>
            <a:ext cx="4474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751"/>
              </a:spcBef>
              <a:tabLst>
                <a:tab algn="l" pos="0"/>
                <a:tab algn="l" pos="4175280"/>
                <a:tab algn="l" pos="83502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84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" name=""/>
          <p:cNvSpPr/>
          <p:nvPr/>
        </p:nvSpPr>
        <p:spPr>
          <a:xfrm>
            <a:off x="37071360" y="26688960"/>
            <a:ext cx="4474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751"/>
              </a:spcBef>
              <a:tabLst>
                <a:tab algn="l" pos="0"/>
                <a:tab algn="l" pos="4175280"/>
                <a:tab algn="l" pos="83502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86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" name=""/>
          <p:cNvSpPr/>
          <p:nvPr/>
        </p:nvSpPr>
        <p:spPr>
          <a:xfrm>
            <a:off x="38900160" y="26688960"/>
            <a:ext cx="4474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751"/>
              </a:spcBef>
              <a:tabLst>
                <a:tab algn="l" pos="0"/>
                <a:tab algn="l" pos="4175280"/>
                <a:tab algn="l" pos="83502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88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" name=""/>
          <p:cNvSpPr/>
          <p:nvPr/>
        </p:nvSpPr>
        <p:spPr>
          <a:xfrm>
            <a:off x="40738320" y="26679600"/>
            <a:ext cx="4478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751"/>
              </a:spcBef>
              <a:tabLst>
                <a:tab algn="l" pos="0"/>
                <a:tab algn="l" pos="4175280"/>
                <a:tab algn="l" pos="83502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9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" name=""/>
          <p:cNvSpPr/>
          <p:nvPr/>
        </p:nvSpPr>
        <p:spPr>
          <a:xfrm>
            <a:off x="34942320" y="2092320"/>
            <a:ext cx="4208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4175280"/>
                <a:tab algn="l" pos="83502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‡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" name=""/>
          <p:cNvSpPr/>
          <p:nvPr/>
        </p:nvSpPr>
        <p:spPr>
          <a:xfrm>
            <a:off x="38244600" y="2117880"/>
            <a:ext cx="4204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4175280"/>
                <a:tab algn="l" pos="83502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‡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" name=""/>
          <p:cNvSpPr/>
          <p:nvPr/>
        </p:nvSpPr>
        <p:spPr>
          <a:xfrm>
            <a:off x="38333520" y="2117880"/>
            <a:ext cx="4204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4175280"/>
                <a:tab algn="l" pos="83502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‡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" name=""/>
          <p:cNvSpPr/>
          <p:nvPr/>
        </p:nvSpPr>
        <p:spPr>
          <a:xfrm>
            <a:off x="2535120" y="15036840"/>
            <a:ext cx="4208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4175280"/>
                <a:tab algn="l" pos="83502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‡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" name=""/>
          <p:cNvSpPr/>
          <p:nvPr/>
        </p:nvSpPr>
        <p:spPr>
          <a:xfrm>
            <a:off x="14649480" y="14395320"/>
            <a:ext cx="0" cy="838440"/>
          </a:xfrm>
          <a:prstGeom prst="line">
            <a:avLst/>
          </a:prstGeom>
          <a:ln w="28440">
            <a:solidFill>
              <a:srgbClr val="000000"/>
            </a:solidFill>
            <a:prstDash val="sysDot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" name=""/>
          <p:cNvSpPr/>
          <p:nvPr/>
        </p:nvSpPr>
        <p:spPr>
          <a:xfrm>
            <a:off x="34623360" y="1409760"/>
            <a:ext cx="0" cy="876240"/>
          </a:xfrm>
          <a:prstGeom prst="line">
            <a:avLst/>
          </a:prstGeom>
          <a:ln w="28440">
            <a:solidFill>
              <a:srgbClr val="000000"/>
            </a:solidFill>
            <a:prstDash val="sysDot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" name=""/>
          <p:cNvSpPr/>
          <p:nvPr/>
        </p:nvSpPr>
        <p:spPr>
          <a:xfrm>
            <a:off x="34614000" y="1409760"/>
            <a:ext cx="1266840" cy="0"/>
          </a:xfrm>
          <a:prstGeom prst="line">
            <a:avLst/>
          </a:prstGeom>
          <a:ln w="28440">
            <a:solidFill>
              <a:srgbClr val="000000"/>
            </a:solidFill>
            <a:prstDash val="sysDot"/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" name=""/>
          <p:cNvSpPr/>
          <p:nvPr/>
        </p:nvSpPr>
        <p:spPr>
          <a:xfrm>
            <a:off x="35290080" y="1190520"/>
            <a:ext cx="379116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1250"/>
              </a:spcBef>
              <a:tabLst>
                <a:tab algn="l" pos="0"/>
                <a:tab algn="l" pos="4175280"/>
                <a:tab algn="l" pos="83502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</a:rPr>
              <a:t>PDEase_I Subdomain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" name=""/>
          <p:cNvSpPr/>
          <p:nvPr/>
        </p:nvSpPr>
        <p:spPr>
          <a:xfrm flipH="1">
            <a:off x="14134680" y="14414400"/>
            <a:ext cx="507960" cy="12960"/>
          </a:xfrm>
          <a:prstGeom prst="line">
            <a:avLst/>
          </a:prstGeom>
          <a:ln w="28440">
            <a:solidFill>
              <a:srgbClr val="000000"/>
            </a:solidFill>
            <a:prstDash val="sysDot"/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33840" bIns="-338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0" name=""/>
          <p:cNvSpPr/>
          <p:nvPr/>
        </p:nvSpPr>
        <p:spPr>
          <a:xfrm>
            <a:off x="8362800" y="14211360"/>
            <a:ext cx="897264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1250"/>
              </a:spcBef>
              <a:tabLst>
                <a:tab algn="l" pos="0"/>
                <a:tab algn="l" pos="4175280"/>
                <a:tab algn="l" pos="83502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"/>
              </a:rPr>
              <a:t>PDEase_</a:t>
            </a:r>
            <a:r>
              <a:rPr b="0" lang="en-US" sz="2000" spc="-1" strike="noStrike">
                <a:solidFill>
                  <a:srgbClr val="000000"/>
                </a:solidFill>
                <a:latin typeface="Times New Roman"/>
              </a:rPr>
              <a:t>I </a:t>
            </a:r>
            <a:r>
              <a:rPr b="0" lang="en-US" sz="2000" spc="-1" strike="noStrike">
                <a:solidFill>
                  <a:srgbClr val="000000"/>
                </a:solidFill>
                <a:latin typeface="Arial"/>
              </a:rPr>
              <a:t>Subdomain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1" name=""/>
          <p:cNvSpPr/>
          <p:nvPr/>
        </p:nvSpPr>
        <p:spPr>
          <a:xfrm>
            <a:off x="1800360" y="14957280"/>
            <a:ext cx="379080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1250"/>
              </a:spcBef>
              <a:tabLst>
                <a:tab algn="l" pos="0"/>
                <a:tab algn="l" pos="4175280"/>
                <a:tab algn="l" pos="83502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</a:rPr>
              <a:t>“</a:t>
            </a:r>
            <a:r>
              <a:rPr b="0" lang="en-US" sz="2000" spc="-1" strike="noStrike">
                <a:solidFill>
                  <a:srgbClr val="000000"/>
                </a:solidFill>
                <a:latin typeface="Times New Roman"/>
              </a:rPr>
              <a:t>KIM” Motif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" name=""/>
          <p:cNvSpPr/>
          <p:nvPr/>
        </p:nvSpPr>
        <p:spPr>
          <a:xfrm flipH="1">
            <a:off x="11023200" y="14414400"/>
            <a:ext cx="507960" cy="12960"/>
          </a:xfrm>
          <a:prstGeom prst="line">
            <a:avLst/>
          </a:prstGeom>
          <a:ln w="28440">
            <a:solidFill>
              <a:srgbClr val="000000"/>
            </a:solidFill>
            <a:prstDash val="sysDot"/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33840" bIns="-338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3" name=""/>
          <p:cNvSpPr/>
          <p:nvPr/>
        </p:nvSpPr>
        <p:spPr>
          <a:xfrm>
            <a:off x="38474640" y="1409760"/>
            <a:ext cx="1266840" cy="0"/>
          </a:xfrm>
          <a:prstGeom prst="line">
            <a:avLst/>
          </a:prstGeom>
          <a:ln w="28440">
            <a:solidFill>
              <a:srgbClr val="000000"/>
            </a:solidFill>
            <a:prstDash val="sysDot"/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6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06-24T02:12:15Z</dcterms:created>
  <dc:creator>Keven Johnson</dc:creator>
  <dc:description/>
  <dc:language>en-US</dc:language>
  <cp:lastModifiedBy>Keven Johnson</cp:lastModifiedBy>
  <dcterms:modified xsi:type="dcterms:W3CDTF">2010-08-02T18:14:13Z</dcterms:modified>
  <cp:revision>17</cp:revision>
  <dc:subject/>
  <dc:title>Slide 1</dc:title>
</cp:coreProperties>
</file>